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  <p:sldId id="256" r:id="rId3"/>
    <p:sldId id="258" r:id="rId4"/>
    <p:sldId id="259" r:id="rId5"/>
    <p:sldId id="282" r:id="rId6"/>
    <p:sldId id="260" r:id="rId7"/>
    <p:sldId id="261" r:id="rId8"/>
    <p:sldId id="262" r:id="rId9"/>
    <p:sldId id="279" r:id="rId10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4546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C968926-4FD8-4F3E-AFAA-46E952D85BDE}" v="8" dt="2025-01-26T09:44:50.15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40" autoAdjust="0"/>
    <p:restoredTop sz="94660"/>
  </p:normalViewPr>
  <p:slideViewPr>
    <p:cSldViewPr snapToGrid="0">
      <p:cViewPr varScale="1">
        <p:scale>
          <a:sx n="78" d="100"/>
          <a:sy n="78" d="100"/>
        </p:scale>
        <p:origin x="87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vid Da Cohen" userId="47ee259a-81f1-413d-bc86-58c2888c9fc5" providerId="ADAL" clId="{BC968926-4FD8-4F3E-AFAA-46E952D85BDE}"/>
    <pc:docChg chg="undo custSel modSld">
      <pc:chgData name="David Da Cohen" userId="47ee259a-81f1-413d-bc86-58c2888c9fc5" providerId="ADAL" clId="{BC968926-4FD8-4F3E-AFAA-46E952D85BDE}" dt="2025-01-26T09:59:07.379" v="269" actId="108"/>
      <pc:docMkLst>
        <pc:docMk/>
      </pc:docMkLst>
      <pc:sldChg chg="modSp mod">
        <pc:chgData name="David Da Cohen" userId="47ee259a-81f1-413d-bc86-58c2888c9fc5" providerId="ADAL" clId="{BC968926-4FD8-4F3E-AFAA-46E952D85BDE}" dt="2025-01-26T09:44:50.156" v="233" actId="1076"/>
        <pc:sldMkLst>
          <pc:docMk/>
          <pc:sldMk cId="1748796989" sldId="256"/>
        </pc:sldMkLst>
        <pc:spChg chg="mod">
          <ac:chgData name="David Da Cohen" userId="47ee259a-81f1-413d-bc86-58c2888c9fc5" providerId="ADAL" clId="{BC968926-4FD8-4F3E-AFAA-46E952D85BDE}" dt="2025-01-26T09:44:50.156" v="233" actId="1076"/>
          <ac:spMkLst>
            <pc:docMk/>
            <pc:sldMk cId="1748796989" sldId="256"/>
            <ac:spMk id="7" creationId="{1D63BD20-74DE-1717-EDB2-95928D8ABFF5}"/>
          </ac:spMkLst>
        </pc:spChg>
        <pc:graphicFrameChg chg="mod modGraphic">
          <ac:chgData name="David Da Cohen" userId="47ee259a-81f1-413d-bc86-58c2888c9fc5" providerId="ADAL" clId="{BC968926-4FD8-4F3E-AFAA-46E952D85BDE}" dt="2025-01-26T09:44:45.477" v="232" actId="1076"/>
          <ac:graphicFrameMkLst>
            <pc:docMk/>
            <pc:sldMk cId="1748796989" sldId="256"/>
            <ac:graphicFrameMk id="6" creationId="{7DF9D266-DE95-7ED7-97EB-4B4C056161A0}"/>
          </ac:graphicFrameMkLst>
        </pc:graphicFrameChg>
      </pc:sldChg>
      <pc:sldChg chg="modSp mod">
        <pc:chgData name="David Da Cohen" userId="47ee259a-81f1-413d-bc86-58c2888c9fc5" providerId="ADAL" clId="{BC968926-4FD8-4F3E-AFAA-46E952D85BDE}" dt="2025-01-23T17:41:55.642" v="225" actId="108"/>
        <pc:sldMkLst>
          <pc:docMk/>
          <pc:sldMk cId="3911614599" sldId="258"/>
        </pc:sldMkLst>
        <pc:spChg chg="mod">
          <ac:chgData name="David Da Cohen" userId="47ee259a-81f1-413d-bc86-58c2888c9fc5" providerId="ADAL" clId="{BC968926-4FD8-4F3E-AFAA-46E952D85BDE}" dt="2025-01-23T17:41:42.744" v="221" actId="20577"/>
          <ac:spMkLst>
            <pc:docMk/>
            <pc:sldMk cId="3911614599" sldId="258"/>
            <ac:spMk id="4" creationId="{D49CF04B-36B6-0420-04BA-4046B7EDD629}"/>
          </ac:spMkLst>
        </pc:spChg>
        <pc:graphicFrameChg chg="mod modGraphic">
          <ac:chgData name="David Da Cohen" userId="47ee259a-81f1-413d-bc86-58c2888c9fc5" providerId="ADAL" clId="{BC968926-4FD8-4F3E-AFAA-46E952D85BDE}" dt="2025-01-23T17:41:55.642" v="225" actId="108"/>
          <ac:graphicFrameMkLst>
            <pc:docMk/>
            <pc:sldMk cId="3911614599" sldId="258"/>
            <ac:graphicFrameMk id="16" creationId="{53A90812-C153-B863-51A6-CA8AD34AEC80}"/>
          </ac:graphicFrameMkLst>
        </pc:graphicFrameChg>
      </pc:sldChg>
      <pc:sldChg chg="modSp mod">
        <pc:chgData name="David Da Cohen" userId="47ee259a-81f1-413d-bc86-58c2888c9fc5" providerId="ADAL" clId="{BC968926-4FD8-4F3E-AFAA-46E952D85BDE}" dt="2025-01-23T17:42:23.627" v="228" actId="108"/>
        <pc:sldMkLst>
          <pc:docMk/>
          <pc:sldMk cId="1994100865" sldId="259"/>
        </pc:sldMkLst>
        <pc:spChg chg="mod">
          <ac:chgData name="David Da Cohen" userId="47ee259a-81f1-413d-bc86-58c2888c9fc5" providerId="ADAL" clId="{BC968926-4FD8-4F3E-AFAA-46E952D85BDE}" dt="2025-01-23T17:42:23.627" v="228" actId="108"/>
          <ac:spMkLst>
            <pc:docMk/>
            <pc:sldMk cId="1994100865" sldId="259"/>
            <ac:spMk id="6" creationId="{C885B1F4-594F-8A9D-BE74-5D7A0A30123E}"/>
          </ac:spMkLst>
        </pc:spChg>
        <pc:graphicFrameChg chg="modGraphic">
          <ac:chgData name="David Da Cohen" userId="47ee259a-81f1-413d-bc86-58c2888c9fc5" providerId="ADAL" clId="{BC968926-4FD8-4F3E-AFAA-46E952D85BDE}" dt="2025-01-23T17:42:10.432" v="226" actId="207"/>
          <ac:graphicFrameMkLst>
            <pc:docMk/>
            <pc:sldMk cId="1994100865" sldId="259"/>
            <ac:graphicFrameMk id="7" creationId="{9B0867BF-A13E-F01A-6FC1-BC9E7717BF1E}"/>
          </ac:graphicFrameMkLst>
        </pc:graphicFrameChg>
        <pc:graphicFrameChg chg="modGraphic">
          <ac:chgData name="David Da Cohen" userId="47ee259a-81f1-413d-bc86-58c2888c9fc5" providerId="ADAL" clId="{BC968926-4FD8-4F3E-AFAA-46E952D85BDE}" dt="2025-01-23T17:42:14.552" v="227" actId="207"/>
          <ac:graphicFrameMkLst>
            <pc:docMk/>
            <pc:sldMk cId="1994100865" sldId="259"/>
            <ac:graphicFrameMk id="8" creationId="{398E5E19-96D4-1614-042B-9E46F59E8BFB}"/>
          </ac:graphicFrameMkLst>
        </pc:graphicFrameChg>
      </pc:sldChg>
      <pc:sldChg chg="modSp mod">
        <pc:chgData name="David Da Cohen" userId="47ee259a-81f1-413d-bc86-58c2888c9fc5" providerId="ADAL" clId="{BC968926-4FD8-4F3E-AFAA-46E952D85BDE}" dt="2025-01-26T09:58:38.425" v="264" actId="207"/>
        <pc:sldMkLst>
          <pc:docMk/>
          <pc:sldMk cId="3820728808" sldId="260"/>
        </pc:sldMkLst>
        <pc:spChg chg="mod">
          <ac:chgData name="David Da Cohen" userId="47ee259a-81f1-413d-bc86-58c2888c9fc5" providerId="ADAL" clId="{BC968926-4FD8-4F3E-AFAA-46E952D85BDE}" dt="2025-01-26T09:57:24.604" v="238" actId="1076"/>
          <ac:spMkLst>
            <pc:docMk/>
            <pc:sldMk cId="3820728808" sldId="260"/>
            <ac:spMk id="3" creationId="{EB71925A-0384-8ADA-AC1A-D28C9EEA2A2A}"/>
          </ac:spMkLst>
        </pc:spChg>
        <pc:spChg chg="mod">
          <ac:chgData name="David Da Cohen" userId="47ee259a-81f1-413d-bc86-58c2888c9fc5" providerId="ADAL" clId="{BC968926-4FD8-4F3E-AFAA-46E952D85BDE}" dt="2025-01-26T09:58:38.425" v="264" actId="207"/>
          <ac:spMkLst>
            <pc:docMk/>
            <pc:sldMk cId="3820728808" sldId="260"/>
            <ac:spMk id="4" creationId="{9F27AF73-649B-8F80-0509-6CE220A036F9}"/>
          </ac:spMkLst>
        </pc:spChg>
        <pc:spChg chg="mod">
          <ac:chgData name="David Da Cohen" userId="47ee259a-81f1-413d-bc86-58c2888c9fc5" providerId="ADAL" clId="{BC968926-4FD8-4F3E-AFAA-46E952D85BDE}" dt="2025-01-26T09:57:24.604" v="238" actId="1076"/>
          <ac:spMkLst>
            <pc:docMk/>
            <pc:sldMk cId="3820728808" sldId="260"/>
            <ac:spMk id="7" creationId="{FE29BBB3-8E80-22A3-5F15-B226DD42EC20}"/>
          </ac:spMkLst>
        </pc:spChg>
        <pc:graphicFrameChg chg="mod">
          <ac:chgData name="David Da Cohen" userId="47ee259a-81f1-413d-bc86-58c2888c9fc5" providerId="ADAL" clId="{BC968926-4FD8-4F3E-AFAA-46E952D85BDE}" dt="2025-01-26T09:57:24.604" v="238" actId="1076"/>
          <ac:graphicFrameMkLst>
            <pc:docMk/>
            <pc:sldMk cId="3820728808" sldId="260"/>
            <ac:graphicFrameMk id="2" creationId="{9F0F54A3-C520-7A8A-E118-A14FAEF3D91F}"/>
          </ac:graphicFrameMkLst>
        </pc:graphicFrameChg>
        <pc:graphicFrameChg chg="mod">
          <ac:chgData name="David Da Cohen" userId="47ee259a-81f1-413d-bc86-58c2888c9fc5" providerId="ADAL" clId="{BC968926-4FD8-4F3E-AFAA-46E952D85BDE}" dt="2025-01-26T09:57:24.604" v="238" actId="1076"/>
          <ac:graphicFrameMkLst>
            <pc:docMk/>
            <pc:sldMk cId="3820728808" sldId="260"/>
            <ac:graphicFrameMk id="5" creationId="{DAFD32AB-A980-AB05-9C00-10E44A027A2F}"/>
          </ac:graphicFrameMkLst>
        </pc:graphicFrameChg>
      </pc:sldChg>
      <pc:sldChg chg="modSp mod">
        <pc:chgData name="David Da Cohen" userId="47ee259a-81f1-413d-bc86-58c2888c9fc5" providerId="ADAL" clId="{BC968926-4FD8-4F3E-AFAA-46E952D85BDE}" dt="2025-01-26T09:59:07.379" v="269" actId="108"/>
        <pc:sldMkLst>
          <pc:docMk/>
          <pc:sldMk cId="440657907" sldId="261"/>
        </pc:sldMkLst>
        <pc:spChg chg="mod">
          <ac:chgData name="David Da Cohen" userId="47ee259a-81f1-413d-bc86-58c2888c9fc5" providerId="ADAL" clId="{BC968926-4FD8-4F3E-AFAA-46E952D85BDE}" dt="2025-01-26T09:59:07.379" v="269" actId="108"/>
          <ac:spMkLst>
            <pc:docMk/>
            <pc:sldMk cId="440657907" sldId="261"/>
            <ac:spMk id="4" creationId="{9F27AF73-649B-8F80-0509-6CE220A036F9}"/>
          </ac:spMkLst>
        </pc:spChg>
      </pc:sldChg>
      <pc:sldChg chg="modSp mod">
        <pc:chgData name="David Da Cohen" userId="47ee259a-81f1-413d-bc86-58c2888c9fc5" providerId="ADAL" clId="{BC968926-4FD8-4F3E-AFAA-46E952D85BDE}" dt="2025-01-26T09:49:24.551" v="234" actId="207"/>
        <pc:sldMkLst>
          <pc:docMk/>
          <pc:sldMk cId="724204498" sldId="262"/>
        </pc:sldMkLst>
        <pc:spChg chg="mod">
          <ac:chgData name="David Da Cohen" userId="47ee259a-81f1-413d-bc86-58c2888c9fc5" providerId="ADAL" clId="{BC968926-4FD8-4F3E-AFAA-46E952D85BDE}" dt="2025-01-26T09:49:24.551" v="234" actId="207"/>
          <ac:spMkLst>
            <pc:docMk/>
            <pc:sldMk cId="724204498" sldId="262"/>
            <ac:spMk id="4" creationId="{5EB265D6-94FF-6DED-3A6C-C237A9216EEA}"/>
          </ac:spMkLst>
        </pc:spChg>
      </pc:sldChg>
      <pc:sldChg chg="addSp delSp modSp mod">
        <pc:chgData name="David Da Cohen" userId="47ee259a-81f1-413d-bc86-58c2888c9fc5" providerId="ADAL" clId="{BC968926-4FD8-4F3E-AFAA-46E952D85BDE}" dt="2025-01-23T17:39:46.178" v="194" actId="108"/>
        <pc:sldMkLst>
          <pc:docMk/>
          <pc:sldMk cId="1763936598" sldId="263"/>
        </pc:sldMkLst>
        <pc:spChg chg="mod">
          <ac:chgData name="David Da Cohen" userId="47ee259a-81f1-413d-bc86-58c2888c9fc5" providerId="ADAL" clId="{BC968926-4FD8-4F3E-AFAA-46E952D85BDE}" dt="2025-01-23T17:39:46.178" v="194" actId="108"/>
          <ac:spMkLst>
            <pc:docMk/>
            <pc:sldMk cId="1763936598" sldId="263"/>
            <ac:spMk id="3" creationId="{3E368C11-0049-EC01-46E2-686BE5E7F2AE}"/>
          </ac:spMkLst>
        </pc:spChg>
        <pc:graphicFrameChg chg="add mod modGraphic">
          <ac:chgData name="David Da Cohen" userId="47ee259a-81f1-413d-bc86-58c2888c9fc5" providerId="ADAL" clId="{BC968926-4FD8-4F3E-AFAA-46E952D85BDE}" dt="2025-01-23T17:27:33.354" v="191" actId="1076"/>
          <ac:graphicFrameMkLst>
            <pc:docMk/>
            <pc:sldMk cId="1763936598" sldId="263"/>
            <ac:graphicFrameMk id="5" creationId="{4030D174-AE33-609A-79AF-8DEDABB012A4}"/>
          </ac:graphicFrameMkLst>
        </pc:graphicFrameChg>
      </pc:sldChg>
      <pc:sldChg chg="modSp mod">
        <pc:chgData name="David Da Cohen" userId="47ee259a-81f1-413d-bc86-58c2888c9fc5" providerId="ADAL" clId="{BC968926-4FD8-4F3E-AFAA-46E952D85BDE}" dt="2025-01-26T09:49:32.777" v="235" actId="207"/>
        <pc:sldMkLst>
          <pc:docMk/>
          <pc:sldMk cId="3677129574" sldId="279"/>
        </pc:sldMkLst>
        <pc:spChg chg="mod">
          <ac:chgData name="David Da Cohen" userId="47ee259a-81f1-413d-bc86-58c2888c9fc5" providerId="ADAL" clId="{BC968926-4FD8-4F3E-AFAA-46E952D85BDE}" dt="2025-01-26T09:49:32.777" v="235" actId="207"/>
          <ac:spMkLst>
            <pc:docMk/>
            <pc:sldMk cId="3677129574" sldId="279"/>
            <ac:spMk id="3" creationId="{7D282314-AD4C-20F9-39AD-D1869F81BC5D}"/>
          </ac:spMkLst>
        </pc:spChg>
      </pc:sldChg>
      <pc:sldChg chg="modSp mod">
        <pc:chgData name="David Da Cohen" userId="47ee259a-81f1-413d-bc86-58c2888c9fc5" providerId="ADAL" clId="{BC968926-4FD8-4F3E-AFAA-46E952D85BDE}" dt="2025-01-23T17:42:49.150" v="231" actId="108"/>
        <pc:sldMkLst>
          <pc:docMk/>
          <pc:sldMk cId="2384394723" sldId="282"/>
        </pc:sldMkLst>
        <pc:spChg chg="mod">
          <ac:chgData name="David Da Cohen" userId="47ee259a-81f1-413d-bc86-58c2888c9fc5" providerId="ADAL" clId="{BC968926-4FD8-4F3E-AFAA-46E952D85BDE}" dt="2025-01-23T17:42:49.150" v="231" actId="108"/>
          <ac:spMkLst>
            <pc:docMk/>
            <pc:sldMk cId="2384394723" sldId="282"/>
            <ac:spMk id="3" creationId="{5DA15980-EED7-7420-9029-B1A7480B5E8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4595B8-7DAF-8B9D-43E6-B969003AEF4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46A17DC-B270-2F2A-226D-D97F3A18F2B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58DD17-95E7-6E8A-EAA0-C7B1D85D25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623372-D0BC-4FC3-949D-8D248DCF4E2C}" type="datetimeFigureOut">
              <a:rPr lang="fr-FR" smtClean="0"/>
              <a:t>23/01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A69C21-1FF6-ACD4-94A3-2E0CABCCCD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31A95B-C5AF-E6E5-2E7A-CE9E96922E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91157-11C0-49A3-9762-6103AD6AF41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1777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44203D-F8E2-702C-0211-0139B6E4CA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AD4A8E-7408-B0A1-CAFA-4608A0BF07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FE4334-26F8-8B02-635A-2E2928B5F5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623372-D0BC-4FC3-949D-8D248DCF4E2C}" type="datetimeFigureOut">
              <a:rPr lang="fr-FR" smtClean="0"/>
              <a:t>23/01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B10121-00DD-159D-FBF8-D22E001D80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9F7610-85F3-B424-2395-525F4172F2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91157-11C0-49A3-9762-6103AD6AF41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8529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E2D9148-2FC7-4A92-7148-11A98C588FB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862D1D-9972-A81F-DE0F-D8A01AE7D7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B171B0-7FA1-3374-0259-21E067A348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623372-D0BC-4FC3-949D-8D248DCF4E2C}" type="datetimeFigureOut">
              <a:rPr lang="fr-FR" smtClean="0"/>
              <a:t>23/01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BA5EE6-79A3-6CCD-066B-102373BEB1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1C65CE-8CBC-708B-4A1C-301754F185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91157-11C0-49A3-9762-6103AD6AF41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16915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E63DA0-F73A-E52E-BD9C-D93BAD844A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9CFEC7-A758-346B-3BAE-5990C4103BD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48B8EB-3DE1-B528-6197-D378416810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623372-D0BC-4FC3-949D-8D248DCF4E2C}" type="datetimeFigureOut">
              <a:rPr lang="fr-FR" smtClean="0"/>
              <a:t>23/01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1F4A00-5A80-2C2E-6526-3D347D6B71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390B08-35C3-ABA6-CE11-6F2F4842D1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91157-11C0-49A3-9762-6103AD6AF41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07109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E7C062-E608-E4D2-F417-637E2DD892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85455A-5180-EBCA-6CCF-AEED0A97FA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302A68-6B4F-05B0-F0AA-429038E1DC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623372-D0BC-4FC3-949D-8D248DCF4E2C}" type="datetimeFigureOut">
              <a:rPr lang="fr-FR" smtClean="0"/>
              <a:t>23/01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A9CD1A-63CB-DE9D-4A01-BE01350ED7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019001-9963-B053-AB19-C57469BE4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91157-11C0-49A3-9762-6103AD6AF41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2016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43E3FB-4881-4DFE-9E63-4A32980ACC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60C3F7-9DC8-1881-F791-9C65BFCEEA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D241F37-8AB8-BC03-3436-F433208EC0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C62188-CF39-CAF1-E344-60AAF2F8B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623372-D0BC-4FC3-949D-8D248DCF4E2C}" type="datetimeFigureOut">
              <a:rPr lang="fr-FR" smtClean="0"/>
              <a:t>23/01/2025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B84A8E-798C-F1DF-D75B-D91B9E2BE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0830D4-33DD-EF27-7A3E-02C652FC39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91157-11C0-49A3-9762-6103AD6AF41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99463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B41AEF-C666-B850-4570-389B2F9365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5F30E3-631D-90EA-3F85-6F9160240F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B26388A-2417-B83B-E4FD-6C0CFF3AC2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58667A9-0042-5BF6-32E5-F021FDC894E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313CA13-F727-F711-7847-3AEDDF3A37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47B3AB3-DB94-365C-294B-74F30CA29F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623372-D0BC-4FC3-949D-8D248DCF4E2C}" type="datetimeFigureOut">
              <a:rPr lang="fr-FR" smtClean="0"/>
              <a:t>23/01/2025</a:t>
            </a:fld>
            <a:endParaRPr lang="fr-FR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EC17A4F-DB73-A0D3-FBB3-3FB0284352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F908174-F3A9-49BC-DFD6-400EBA3A70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91157-11C0-49A3-9762-6103AD6AF41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058678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1AB3F9-F73F-0147-3CE9-90242CD841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3E7296E-9CCE-45AF-A75D-E6678B1C41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623372-D0BC-4FC3-949D-8D248DCF4E2C}" type="datetimeFigureOut">
              <a:rPr lang="fr-FR" smtClean="0"/>
              <a:t>23/01/2025</a:t>
            </a:fld>
            <a:endParaRPr lang="fr-FR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31A10EF-65D2-E71B-1340-81CEAEB683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4529C7C-8882-4397-E9BC-078118FBC1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91157-11C0-49A3-9762-6103AD6AF41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99526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737D5EE-2107-9986-F6B6-FEC4FFA9E8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623372-D0BC-4FC3-949D-8D248DCF4E2C}" type="datetimeFigureOut">
              <a:rPr lang="fr-FR" smtClean="0"/>
              <a:t>23/01/2025</a:t>
            </a:fld>
            <a:endParaRPr lang="fr-FR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0DECC89-C3BA-D9CE-9EA8-5B6D8635C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C4CF971-861F-E8AD-ED85-2236956D3E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91157-11C0-49A3-9762-6103AD6AF41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9317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196207-3546-3306-D1D2-F4B1220933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BC74EF-4896-43D1-4200-70A95ECCC1D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88F01B-4B92-67A9-5FC6-3089759A4A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94E012-0DA9-DFA8-3742-D8753E4066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623372-D0BC-4FC3-949D-8D248DCF4E2C}" type="datetimeFigureOut">
              <a:rPr lang="fr-FR" smtClean="0"/>
              <a:t>23/01/2025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717B01-4756-BD5C-9D5C-C722785128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127997-EA24-2AA7-4410-70A602B7B4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91157-11C0-49A3-9762-6103AD6AF41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33899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E2F5C7-DEF7-79EF-DEB4-33D33C8EDC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8C45A36-EB9B-941B-1842-DBAAD7306D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FEBF97-C87D-E803-3081-13D55F56BD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9EB97F-B970-BDA9-0BCA-5865475226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623372-D0BC-4FC3-949D-8D248DCF4E2C}" type="datetimeFigureOut">
              <a:rPr lang="fr-FR" smtClean="0"/>
              <a:t>23/01/2025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49F1ED-3C03-FFDB-B39A-8489271529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C02F78-02D7-DEA8-C8AE-DB2CF5C7E5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91157-11C0-49A3-9762-6103AD6AF41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1481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5A66145-B404-7DCC-50B9-5C1BCC7251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5F0B089-0194-CCFF-F435-66089B9331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AAB9E7-DF67-FF44-906F-4379A73B279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6623372-D0BC-4FC3-949D-8D248DCF4E2C}" type="datetimeFigureOut">
              <a:rPr lang="fr-FR" smtClean="0"/>
              <a:t>23/01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E052B9-72C0-604C-8AA0-6AFCBFD9F8A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E4A7DF-E736-B538-D022-8B0A829ADAA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FF91157-11C0-49A3-9762-6103AD6AF41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24709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1">
            <a:extLst>
              <a:ext uri="{FF2B5EF4-FFF2-40B4-BE49-F238E27FC236}">
                <a16:creationId xmlns:a16="http://schemas.microsoft.com/office/drawing/2014/main" id="{3E368C11-0049-EC01-46E2-686BE5E7F2AE}"/>
              </a:ext>
            </a:extLst>
          </p:cNvPr>
          <p:cNvSpPr txBox="1"/>
          <p:nvPr/>
        </p:nvSpPr>
        <p:spPr>
          <a:xfrm>
            <a:off x="689808" y="553541"/>
            <a:ext cx="10858725" cy="882552"/>
          </a:xfrm>
          <a:prstGeom prst="rect">
            <a:avLst/>
          </a:prstGeom>
          <a:solidFill>
            <a:prstClr val="white"/>
          </a:solidFill>
          <a:ln>
            <a:noFill/>
          </a:ln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defTabSz="1773936"/>
            <a:r>
              <a:rPr kumimoji="0" lang="en-US" altLang="fr-FR" sz="12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1</a:t>
            </a:r>
          </a:p>
          <a:p>
            <a:pPr defTabSz="1773936">
              <a:spcAft>
                <a:spcPts val="1940"/>
              </a:spcAft>
            </a:pPr>
            <a:r>
              <a:rPr lang="en-US" sz="1200" dirty="0">
                <a:solidFill>
                  <a:srgbClr val="44546A"/>
                </a:solidFill>
                <a:latin typeface="Times New Roman" panose="02020603050405020304" pitchFamily="18" charset="0"/>
              </a:rPr>
              <a:t>Effect of soil age on its chemical parameters. </a:t>
            </a:r>
            <a:r>
              <a:rPr lang="fr-FR" sz="1200" dirty="0" err="1">
                <a:solidFill>
                  <a:srgbClr val="44546A"/>
                </a:solidFill>
                <a:latin typeface="Times New Roman" panose="02020603050405020304" pitchFamily="18" charset="0"/>
              </a:rPr>
              <a:t>Parameters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</a:rPr>
              <a:t> </a:t>
            </a:r>
            <a:r>
              <a:rPr lang="fr-FR" sz="1200" dirty="0" err="1">
                <a:solidFill>
                  <a:srgbClr val="44546A"/>
                </a:solidFill>
                <a:latin typeface="Times New Roman" panose="02020603050405020304" pitchFamily="18" charset="0"/>
              </a:rPr>
              <a:t>were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</a:rPr>
              <a:t> </a:t>
            </a:r>
            <a:r>
              <a:rPr lang="fr-FR" sz="1200" dirty="0" err="1">
                <a:solidFill>
                  <a:srgbClr val="44546A"/>
                </a:solidFill>
                <a:latin typeface="Times New Roman" panose="02020603050405020304" pitchFamily="18" charset="0"/>
              </a:rPr>
              <a:t>analyzed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</a:rPr>
              <a:t> for </a:t>
            </a:r>
            <a:r>
              <a:rPr lang="fr-FR" sz="1200" dirty="0" err="1">
                <a:solidFill>
                  <a:srgbClr val="44546A"/>
                </a:solidFill>
                <a:latin typeface="Times New Roman" panose="02020603050405020304" pitchFamily="18" charset="0"/>
              </a:rPr>
              <a:t>soils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</a:rPr>
              <a:t> </a:t>
            </a:r>
            <a:r>
              <a:rPr lang="fr-FR" sz="1200" dirty="0" err="1">
                <a:solidFill>
                  <a:srgbClr val="44546A"/>
                </a:solidFill>
                <a:latin typeface="Times New Roman" panose="02020603050405020304" pitchFamily="18" charset="0"/>
              </a:rPr>
              <a:t>aged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</a:rPr>
              <a:t> 0, 6, 18, 30, and 42 </a:t>
            </a:r>
            <a:r>
              <a:rPr lang="fr-FR" sz="1200" dirty="0" err="1">
                <a:solidFill>
                  <a:srgbClr val="44546A"/>
                </a:solidFill>
                <a:latin typeface="Times New Roman" panose="02020603050405020304" pitchFamily="18" charset="0"/>
              </a:rPr>
              <a:t>months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</a:rPr>
              <a:t>, in </a:t>
            </a:r>
            <a:r>
              <a:rPr lang="fr-FR" sz="1200" dirty="0" err="1">
                <a:solidFill>
                  <a:srgbClr val="44546A"/>
                </a:solidFill>
                <a:latin typeface="Times New Roman" panose="02020603050405020304" pitchFamily="18" charset="0"/>
              </a:rPr>
              <a:t>three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</a:rPr>
              <a:t> </a:t>
            </a:r>
            <a:r>
              <a:rPr lang="fr-FR" sz="1200" dirty="0" err="1">
                <a:solidFill>
                  <a:srgbClr val="44546A"/>
                </a:solidFill>
                <a:latin typeface="Times New Roman" panose="02020603050405020304" pitchFamily="18" charset="0"/>
              </a:rPr>
              <a:t>replicates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</a:rPr>
              <a:t>. TOC, total </a:t>
            </a:r>
            <a:r>
              <a:rPr lang="fr-FR" sz="1200" dirty="0" err="1">
                <a:solidFill>
                  <a:srgbClr val="44546A"/>
                </a:solidFill>
                <a:latin typeface="Times New Roman" panose="02020603050405020304" pitchFamily="18" charset="0"/>
              </a:rPr>
              <a:t>organic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</a:rPr>
              <a:t> </a:t>
            </a:r>
            <a:r>
              <a:rPr lang="fr-FR" sz="1200" dirty="0" err="1">
                <a:solidFill>
                  <a:srgbClr val="44546A"/>
                </a:solidFill>
                <a:latin typeface="Times New Roman" panose="02020603050405020304" pitchFamily="18" charset="0"/>
              </a:rPr>
              <a:t>carbon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</a:rPr>
              <a:t>; SAR, sodium adsorption ratio.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4030D174-AE33-609A-79AF-8DEDABB012A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6802864"/>
              </p:ext>
            </p:extLst>
          </p:nvPr>
        </p:nvGraphicFramePr>
        <p:xfrm>
          <a:off x="540775" y="1691149"/>
          <a:ext cx="11289858" cy="3129683"/>
        </p:xfrm>
        <a:graphic>
          <a:graphicData uri="http://schemas.openxmlformats.org/drawingml/2006/table">
            <a:tbl>
              <a:tblPr/>
              <a:tblGrid>
                <a:gridCol w="501444">
                  <a:extLst>
                    <a:ext uri="{9D8B030D-6E8A-4147-A177-3AD203B41FA5}">
                      <a16:colId xmlns:a16="http://schemas.microsoft.com/office/drawing/2014/main" val="983440085"/>
                    </a:ext>
                  </a:extLst>
                </a:gridCol>
                <a:gridCol w="727191">
                  <a:extLst>
                    <a:ext uri="{9D8B030D-6E8A-4147-A177-3AD203B41FA5}">
                      <a16:colId xmlns:a16="http://schemas.microsoft.com/office/drawing/2014/main" val="2064848970"/>
                    </a:ext>
                  </a:extLst>
                </a:gridCol>
                <a:gridCol w="685505">
                  <a:extLst>
                    <a:ext uri="{9D8B030D-6E8A-4147-A177-3AD203B41FA5}">
                      <a16:colId xmlns:a16="http://schemas.microsoft.com/office/drawing/2014/main" val="769146022"/>
                    </a:ext>
                  </a:extLst>
                </a:gridCol>
                <a:gridCol w="643321">
                  <a:extLst>
                    <a:ext uri="{9D8B030D-6E8A-4147-A177-3AD203B41FA5}">
                      <a16:colId xmlns:a16="http://schemas.microsoft.com/office/drawing/2014/main" val="932821644"/>
                    </a:ext>
                  </a:extLst>
                </a:gridCol>
                <a:gridCol w="448215">
                  <a:extLst>
                    <a:ext uri="{9D8B030D-6E8A-4147-A177-3AD203B41FA5}">
                      <a16:colId xmlns:a16="http://schemas.microsoft.com/office/drawing/2014/main" val="2378552928"/>
                    </a:ext>
                  </a:extLst>
                </a:gridCol>
                <a:gridCol w="1128448">
                  <a:extLst>
                    <a:ext uri="{9D8B030D-6E8A-4147-A177-3AD203B41FA5}">
                      <a16:colId xmlns:a16="http://schemas.microsoft.com/office/drawing/2014/main" val="2249477736"/>
                    </a:ext>
                  </a:extLst>
                </a:gridCol>
                <a:gridCol w="585359">
                  <a:extLst>
                    <a:ext uri="{9D8B030D-6E8A-4147-A177-3AD203B41FA5}">
                      <a16:colId xmlns:a16="http://schemas.microsoft.com/office/drawing/2014/main" val="1462515389"/>
                    </a:ext>
                  </a:extLst>
                </a:gridCol>
                <a:gridCol w="511450">
                  <a:extLst>
                    <a:ext uri="{9D8B030D-6E8A-4147-A177-3AD203B41FA5}">
                      <a16:colId xmlns:a16="http://schemas.microsoft.com/office/drawing/2014/main" val="767878520"/>
                    </a:ext>
                  </a:extLst>
                </a:gridCol>
                <a:gridCol w="769875">
                  <a:extLst>
                    <a:ext uri="{9D8B030D-6E8A-4147-A177-3AD203B41FA5}">
                      <a16:colId xmlns:a16="http://schemas.microsoft.com/office/drawing/2014/main" val="4207411346"/>
                    </a:ext>
                  </a:extLst>
                </a:gridCol>
                <a:gridCol w="766582">
                  <a:extLst>
                    <a:ext uri="{9D8B030D-6E8A-4147-A177-3AD203B41FA5}">
                      <a16:colId xmlns:a16="http://schemas.microsoft.com/office/drawing/2014/main" val="2902586915"/>
                    </a:ext>
                  </a:extLst>
                </a:gridCol>
                <a:gridCol w="764995">
                  <a:extLst>
                    <a:ext uri="{9D8B030D-6E8A-4147-A177-3AD203B41FA5}">
                      <a16:colId xmlns:a16="http://schemas.microsoft.com/office/drawing/2014/main" val="212309308"/>
                    </a:ext>
                  </a:extLst>
                </a:gridCol>
                <a:gridCol w="804526">
                  <a:extLst>
                    <a:ext uri="{9D8B030D-6E8A-4147-A177-3AD203B41FA5}">
                      <a16:colId xmlns:a16="http://schemas.microsoft.com/office/drawing/2014/main" val="2704268075"/>
                    </a:ext>
                  </a:extLst>
                </a:gridCol>
                <a:gridCol w="543132">
                  <a:extLst>
                    <a:ext uri="{9D8B030D-6E8A-4147-A177-3AD203B41FA5}">
                      <a16:colId xmlns:a16="http://schemas.microsoft.com/office/drawing/2014/main" val="2844408331"/>
                    </a:ext>
                  </a:extLst>
                </a:gridCol>
                <a:gridCol w="796240">
                  <a:extLst>
                    <a:ext uri="{9D8B030D-6E8A-4147-A177-3AD203B41FA5}">
                      <a16:colId xmlns:a16="http://schemas.microsoft.com/office/drawing/2014/main" val="2511329641"/>
                    </a:ext>
                  </a:extLst>
                </a:gridCol>
                <a:gridCol w="638047">
                  <a:extLst>
                    <a:ext uri="{9D8B030D-6E8A-4147-A177-3AD203B41FA5}">
                      <a16:colId xmlns:a16="http://schemas.microsoft.com/office/drawing/2014/main" val="2939510090"/>
                    </a:ext>
                  </a:extLst>
                </a:gridCol>
                <a:gridCol w="485127">
                  <a:extLst>
                    <a:ext uri="{9D8B030D-6E8A-4147-A177-3AD203B41FA5}">
                      <a16:colId xmlns:a16="http://schemas.microsoft.com/office/drawing/2014/main" val="1122368002"/>
                    </a:ext>
                  </a:extLst>
                </a:gridCol>
                <a:gridCol w="490401">
                  <a:extLst>
                    <a:ext uri="{9D8B030D-6E8A-4147-A177-3AD203B41FA5}">
                      <a16:colId xmlns:a16="http://schemas.microsoft.com/office/drawing/2014/main" val="46817420"/>
                    </a:ext>
                  </a:extLst>
                </a:gridCol>
              </a:tblGrid>
              <a:tr h="36819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il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ge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</a:t>
                      </a:r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nths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ductivity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</a:t>
                      </a:r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S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</a:t>
                      </a:r>
                      <a:r>
                        <a:rPr lang="fr-FR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loride (mEq L</a:t>
                      </a:r>
                      <a:r>
                        <a:rPr lang="fr-FR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dium (mEq L</a:t>
                      </a:r>
                      <a:r>
                        <a:rPr lang="fr-FR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H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lcium+magnesium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mEq L</a:t>
                      </a:r>
                      <a:r>
                        <a:rPr lang="fr-FR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lsen P (mg kg</a:t>
                      </a:r>
                      <a:r>
                        <a:rPr lang="fr-FR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 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R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tassium  (mg kg</a:t>
                      </a:r>
                      <a:r>
                        <a:rPr lang="fr-FR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 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on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mg kg</a:t>
                      </a:r>
                      <a:r>
                        <a:rPr lang="fr-FR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 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inc (mg kg</a:t>
                      </a:r>
                      <a:r>
                        <a:rPr lang="fr-FR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 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nganese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mg kg</a:t>
                      </a:r>
                      <a:r>
                        <a:rPr lang="fr-FR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 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oron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mg L</a:t>
                      </a:r>
                      <a:r>
                        <a:rPr lang="fr-FR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 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mmonium (mg kg</a:t>
                      </a:r>
                      <a:r>
                        <a:rPr lang="fr-FR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 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itrate (mg kg</a:t>
                      </a:r>
                      <a:r>
                        <a:rPr lang="fr-FR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 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V 254 (nm)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C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7738060"/>
                  </a:ext>
                </a:extLst>
              </a:tr>
              <a:tr h="184099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1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2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25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7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8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.8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.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6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8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1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1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6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17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03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13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1650299"/>
                  </a:ext>
                </a:extLst>
              </a:tr>
              <a:tr h="184099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4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25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7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6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.6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3.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4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6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9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90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57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73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3003881"/>
                  </a:ext>
                </a:extLst>
              </a:tr>
              <a:tr h="184099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9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6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6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.8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5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1.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22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0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.1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62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5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35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91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0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361395"/>
                  </a:ext>
                </a:extLst>
              </a:tr>
              <a:tr h="184099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9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0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37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2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5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.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5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5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1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015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1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8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8522245"/>
                  </a:ext>
                </a:extLst>
              </a:tr>
              <a:tr h="184099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7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32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5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7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6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.5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02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7.7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3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9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2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1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1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66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11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49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06539703"/>
                  </a:ext>
                </a:extLst>
              </a:tr>
              <a:tr h="184099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7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2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0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7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2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.52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9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6.9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2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8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8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141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0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3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6678381"/>
                  </a:ext>
                </a:extLst>
              </a:tr>
              <a:tr h="184099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52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87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2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.0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.7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0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82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9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5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0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17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6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43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6393163"/>
                  </a:ext>
                </a:extLst>
              </a:tr>
              <a:tr h="184099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6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12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7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5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92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2.1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5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.9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3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8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67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51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5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12103953"/>
                  </a:ext>
                </a:extLst>
              </a:tr>
              <a:tr h="184099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5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6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5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22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.6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1.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0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2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0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751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29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72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1086534"/>
                  </a:ext>
                </a:extLst>
              </a:tr>
              <a:tr h="184099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6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5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9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.0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6.2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9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0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3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0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83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02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3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6148957"/>
                  </a:ext>
                </a:extLst>
              </a:tr>
              <a:tr h="184099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3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37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6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.2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5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.9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5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0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9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1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135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4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01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9328901"/>
                  </a:ext>
                </a:extLst>
              </a:tr>
              <a:tr h="184099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8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12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8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.8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8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.1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8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0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.0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5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9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91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89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63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54105281"/>
                  </a:ext>
                </a:extLst>
              </a:tr>
              <a:tr h="184099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5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4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12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5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0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28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5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.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1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8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1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56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9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99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6806692"/>
                  </a:ext>
                </a:extLst>
              </a:tr>
              <a:tr h="184099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7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62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5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36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6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5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.7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4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0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5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8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399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77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39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81874082"/>
                  </a:ext>
                </a:extLst>
              </a:tr>
              <a:tr h="184099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9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2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87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7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.6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29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3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5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0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4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9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40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604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22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.12</a:t>
                      </a:r>
                    </a:p>
                  </a:txBody>
                  <a:tcPr marL="3085" marR="3085" marT="308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74135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639365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7DF9D266-DE95-7ED7-97EB-4B4C056161A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10941790"/>
              </p:ext>
            </p:extLst>
          </p:nvPr>
        </p:nvGraphicFramePr>
        <p:xfrm>
          <a:off x="1950821" y="1200697"/>
          <a:ext cx="2286882" cy="5412980"/>
        </p:xfrm>
        <a:graphic>
          <a:graphicData uri="http://schemas.openxmlformats.org/drawingml/2006/table">
            <a:tbl>
              <a:tblPr firstRow="1" firstCol="1" bandRow="1"/>
              <a:tblGrid>
                <a:gridCol w="1582430">
                  <a:extLst>
                    <a:ext uri="{9D8B030D-6E8A-4147-A177-3AD203B41FA5}">
                      <a16:colId xmlns:a16="http://schemas.microsoft.com/office/drawing/2014/main" val="1471333815"/>
                    </a:ext>
                  </a:extLst>
                </a:gridCol>
                <a:gridCol w="704452">
                  <a:extLst>
                    <a:ext uri="{9D8B030D-6E8A-4147-A177-3AD203B41FA5}">
                      <a16:colId xmlns:a16="http://schemas.microsoft.com/office/drawing/2014/main" val="790187350"/>
                    </a:ext>
                  </a:extLst>
                </a:gridCol>
              </a:tblGrid>
              <a:tr h="35685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b="1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 Parameter</a:t>
                      </a:r>
                      <a:endParaRPr lang="fr-FR" sz="1600" b="1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400" b="1" i="1" kern="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p</a:t>
                      </a:r>
                      <a:r>
                        <a:rPr lang="fr-FR" sz="1400" b="1" kern="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-v</a:t>
                      </a:r>
                      <a:r>
                        <a:rPr lang="fr-FR" sz="1400" b="1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alue</a:t>
                      </a:r>
                      <a:endParaRPr lang="fr-FR" sz="1800" b="1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27209951"/>
                  </a:ext>
                </a:extLst>
              </a:tr>
              <a:tr h="324917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pH</a:t>
                      </a:r>
                      <a:endParaRPr lang="fr-FR" sz="1600" b="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40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0.004</a:t>
                      </a:r>
                      <a:endParaRPr lang="fr-FR" sz="180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42702609"/>
                  </a:ext>
                </a:extLst>
              </a:tr>
              <a:tr h="324917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0" dirty="0" err="1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Iron</a:t>
                      </a:r>
                      <a:endParaRPr lang="fr-FR" sz="1600" b="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40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0.076</a:t>
                      </a:r>
                      <a:endParaRPr lang="fr-FR" sz="180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4253034"/>
                  </a:ext>
                </a:extLst>
              </a:tr>
              <a:tr h="324917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TOC</a:t>
                      </a:r>
                      <a:endParaRPr lang="fr-FR" sz="1600" b="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40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0.141</a:t>
                      </a:r>
                      <a:endParaRPr lang="fr-FR" sz="180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11463468"/>
                  </a:ext>
                </a:extLst>
              </a:tr>
              <a:tr h="324917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Nitrate</a:t>
                      </a:r>
                      <a:endParaRPr lang="fr-FR" sz="1600" b="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40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0.215</a:t>
                      </a:r>
                      <a:endParaRPr lang="fr-FR" sz="180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85765747"/>
                  </a:ext>
                </a:extLst>
              </a:tr>
              <a:tr h="487913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0" dirty="0" err="1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Calciu</a:t>
                      </a:r>
                      <a:r>
                        <a:rPr lang="fr-FR" sz="1200" b="0" kern="0" dirty="0" err="1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m+magnesium</a:t>
                      </a:r>
                      <a:endParaRPr lang="fr-FR" sz="1600" b="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40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0.253</a:t>
                      </a:r>
                      <a:endParaRPr lang="fr-FR" sz="180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7336774"/>
                  </a:ext>
                </a:extLst>
              </a:tr>
              <a:tr h="324917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Potassium</a:t>
                      </a:r>
                      <a:endParaRPr lang="fr-FR" sz="1600" b="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40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0.378</a:t>
                      </a:r>
                      <a:endParaRPr lang="fr-FR" sz="180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364141"/>
                  </a:ext>
                </a:extLst>
              </a:tr>
              <a:tr h="324917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UV</a:t>
                      </a:r>
                      <a:endParaRPr lang="fr-FR" sz="1600" b="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40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0.584</a:t>
                      </a:r>
                      <a:endParaRPr lang="fr-FR" sz="180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250756"/>
                  </a:ext>
                </a:extLst>
              </a:tr>
              <a:tr h="324917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Chloride</a:t>
                      </a:r>
                      <a:endParaRPr lang="fr-FR" sz="1600" b="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40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0.595</a:t>
                      </a:r>
                      <a:endParaRPr lang="fr-FR" sz="180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20716458"/>
                  </a:ext>
                </a:extLst>
              </a:tr>
              <a:tr h="324917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Olsen P</a:t>
                      </a:r>
                      <a:endParaRPr lang="fr-FR" sz="1600" b="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40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0.599</a:t>
                      </a:r>
                      <a:endParaRPr lang="fr-FR" sz="180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8014027"/>
                  </a:ext>
                </a:extLst>
              </a:tr>
              <a:tr h="324917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0" dirty="0" err="1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Conductivity</a:t>
                      </a:r>
                      <a:endParaRPr lang="fr-FR" sz="1600" b="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40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0.621</a:t>
                      </a:r>
                      <a:endParaRPr lang="fr-FR" sz="180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36313563"/>
                  </a:ext>
                </a:extLst>
              </a:tr>
              <a:tr h="324917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SAR</a:t>
                      </a:r>
                      <a:endParaRPr lang="fr-FR" sz="1600" b="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40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0.660</a:t>
                      </a:r>
                      <a:endParaRPr lang="fr-FR" sz="180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57518543"/>
                  </a:ext>
                </a:extLst>
              </a:tr>
              <a:tr h="324917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0" dirty="0" err="1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Boron</a:t>
                      </a:r>
                      <a:endParaRPr lang="fr-FR" sz="1600" b="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40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0.794</a:t>
                      </a:r>
                      <a:endParaRPr lang="fr-FR" sz="180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49041575"/>
                  </a:ext>
                </a:extLst>
              </a:tr>
              <a:tr h="324917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Zinc</a:t>
                      </a:r>
                      <a:endParaRPr lang="fr-FR" sz="1600" b="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40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0.808</a:t>
                      </a:r>
                      <a:endParaRPr lang="fr-FR" sz="180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6934434"/>
                  </a:ext>
                </a:extLst>
              </a:tr>
              <a:tr h="324917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Sodium</a:t>
                      </a:r>
                      <a:endParaRPr lang="fr-FR" sz="1600" b="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40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0.808</a:t>
                      </a:r>
                      <a:endParaRPr lang="fr-FR" sz="180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6641767"/>
                  </a:ext>
                </a:extLst>
              </a:tr>
              <a:tr h="324917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0" dirty="0" err="1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Manganese</a:t>
                      </a:r>
                      <a:endParaRPr lang="fr-FR" sz="1600" b="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400" kern="0" dirty="0">
                          <a:solidFill>
                            <a:srgbClr val="000000"/>
                          </a:solidFill>
                          <a:effectLst/>
                          <a:latin typeface="David" panose="020E0502060401010101" pitchFamily="34" charset="-79"/>
                          <a:ea typeface="Times New Roman" panose="02020603050405020304" pitchFamily="18" charset="0"/>
                          <a:cs typeface="David" panose="020E0502060401010101" pitchFamily="34" charset="-79"/>
                        </a:rPr>
                        <a:t>0.830</a:t>
                      </a:r>
                      <a:endParaRPr lang="fr-FR" sz="180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8762545"/>
                  </a:ext>
                </a:extLst>
              </a:tr>
            </a:tbl>
          </a:graphicData>
        </a:graphic>
      </p:graphicFrame>
      <p:sp>
        <p:nvSpPr>
          <p:cNvPr id="7" name="Rectangle 2">
            <a:extLst>
              <a:ext uri="{FF2B5EF4-FFF2-40B4-BE49-F238E27FC236}">
                <a16:creationId xmlns:a16="http://schemas.microsoft.com/office/drawing/2014/main" id="{1D63BD20-74DE-1717-EDB2-95928D8ABF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5092" y="244323"/>
            <a:ext cx="7246374" cy="830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2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fr-FR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oil chemistry analysis of variance. 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</a:t>
            </a:r>
            <a:r>
              <a:rPr lang="fr-FR" sz="1200" dirty="0" err="1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howing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atistical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ults of one-way ANOVA with </a:t>
            </a:r>
            <a:r>
              <a:rPr lang="fr-FR" sz="1200" i="1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values for </a:t>
            </a:r>
            <a:r>
              <a:rPr lang="fr-FR" sz="1200" dirty="0" err="1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rious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vironmental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rameters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A </a:t>
            </a:r>
            <a:r>
              <a:rPr lang="fr-FR" sz="1200" dirty="0" err="1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gnificant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200" i="1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value (e.g., </a:t>
            </a:r>
            <a:r>
              <a:rPr lang="fr-FR" sz="1200" i="1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lt; 0.05) </a:t>
            </a:r>
            <a:r>
              <a:rPr lang="fr-FR" sz="1200" dirty="0" err="1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dicates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 </a:t>
            </a:r>
            <a:r>
              <a:rPr lang="fr-FR" sz="1200" dirty="0" err="1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atistically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gnificant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ssociation. TOC, total </a:t>
            </a:r>
            <a:r>
              <a:rPr lang="fr-FR" sz="1200" dirty="0" err="1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rganic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rbon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SAR, sodium adsorption ratio.</a:t>
            </a:r>
            <a:endParaRPr lang="en-US" altLang="fr-FR" sz="1200" dirty="0">
              <a:solidFill>
                <a:srgbClr val="44546A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87969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id="{53A90812-C153-B863-51A6-CA8AD34AEC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24025034"/>
              </p:ext>
            </p:extLst>
          </p:nvPr>
        </p:nvGraphicFramePr>
        <p:xfrm>
          <a:off x="2114066" y="3667634"/>
          <a:ext cx="2871649" cy="166662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930718">
                  <a:extLst>
                    <a:ext uri="{9D8B030D-6E8A-4147-A177-3AD203B41FA5}">
                      <a16:colId xmlns:a16="http://schemas.microsoft.com/office/drawing/2014/main" val="2217372513"/>
                    </a:ext>
                  </a:extLst>
                </a:gridCol>
                <a:gridCol w="940931">
                  <a:extLst>
                    <a:ext uri="{9D8B030D-6E8A-4147-A177-3AD203B41FA5}">
                      <a16:colId xmlns:a16="http://schemas.microsoft.com/office/drawing/2014/main" val="1131411218"/>
                    </a:ext>
                  </a:extLst>
                </a:gridCol>
              </a:tblGrid>
              <a:tr h="308715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Pair</a:t>
                      </a:r>
                      <a:endParaRPr lang="fr-FR" sz="1200" dirty="0">
                        <a:latin typeface="David" panose="020E0502060401010101" pitchFamily="34" charset="-79"/>
                        <a:cs typeface="David" panose="020E0502060401010101" pitchFamily="34" charset="-79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FDR</a:t>
                      </a:r>
                      <a:endParaRPr lang="fr-FR" sz="1200" dirty="0">
                        <a:latin typeface="David" panose="020E0502060401010101" pitchFamily="34" charset="-79"/>
                        <a:cs typeface="David" panose="020E0502060401010101" pitchFamily="34" charset="-79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98317736"/>
                  </a:ext>
                </a:extLst>
              </a:tr>
              <a:tr h="771787">
                <a:tc>
                  <a:txBody>
                    <a:bodyPr/>
                    <a:lstStyle/>
                    <a:p>
                      <a:r>
                        <a:rPr lang="en-US" sz="1200" dirty="0" err="1"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Soil_</a:t>
                      </a:r>
                      <a:r>
                        <a:rPr lang="en-US" sz="1200" kern="1200" dirty="0" err="1">
                          <a:solidFill>
                            <a:schemeClr val="tx1"/>
                          </a:solidFill>
                          <a:latin typeface="David" panose="020E0502060401010101" pitchFamily="34" charset="-79"/>
                          <a:ea typeface="+mn-ea"/>
                          <a:cs typeface="David" panose="020E0502060401010101" pitchFamily="34" charset="-79"/>
                        </a:rPr>
                        <a:t>far</a:t>
                      </a: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David" panose="020E0502060401010101" pitchFamily="34" charset="-79"/>
                          <a:ea typeface="+mn-ea"/>
                          <a:cs typeface="David" panose="020E0502060401010101" pitchFamily="34" charset="-79"/>
                        </a:rPr>
                        <a:t> vs. </a:t>
                      </a:r>
                      <a:r>
                        <a:rPr lang="en-US" sz="1200" dirty="0" err="1"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Soil_near</a:t>
                      </a:r>
                      <a:r>
                        <a:rPr lang="en-US" sz="1200" dirty="0"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 (16S)</a:t>
                      </a:r>
                      <a:endParaRPr lang="fr-FR" sz="1200" dirty="0">
                        <a:latin typeface="David" panose="020E0502060401010101" pitchFamily="34" charset="-79"/>
                        <a:cs typeface="David" panose="020E0502060401010101" pitchFamily="34" charset="-79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0.99</a:t>
                      </a:r>
                      <a:endParaRPr lang="fr-FR" sz="1200" dirty="0">
                        <a:latin typeface="David" panose="020E0502060401010101" pitchFamily="34" charset="-79"/>
                        <a:cs typeface="David" panose="020E0502060401010101" pitchFamily="34" charset="-79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21847720"/>
                  </a:ext>
                </a:extLst>
              </a:tr>
              <a:tr h="58612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err="1"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Soil_</a:t>
                      </a:r>
                      <a:r>
                        <a:rPr lang="en-US" sz="1200" kern="1200" dirty="0" err="1">
                          <a:solidFill>
                            <a:schemeClr val="tx1"/>
                          </a:solidFill>
                          <a:latin typeface="David" panose="020E0502060401010101" pitchFamily="34" charset="-79"/>
                          <a:ea typeface="+mn-ea"/>
                          <a:cs typeface="David" panose="020E0502060401010101" pitchFamily="34" charset="-79"/>
                        </a:rPr>
                        <a:t>far</a:t>
                      </a: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David" panose="020E0502060401010101" pitchFamily="34" charset="-79"/>
                          <a:ea typeface="+mn-ea"/>
                          <a:cs typeface="David" panose="020E0502060401010101" pitchFamily="34" charset="-79"/>
                        </a:rPr>
                        <a:t> vs. </a:t>
                      </a:r>
                      <a:r>
                        <a:rPr lang="en-US" sz="1200" kern="1200" dirty="0" err="1">
                          <a:solidFill>
                            <a:schemeClr val="tx1"/>
                          </a:solidFill>
                          <a:latin typeface="David" panose="020E0502060401010101" pitchFamily="34" charset="-79"/>
                          <a:ea typeface="+mn-ea"/>
                          <a:cs typeface="David" panose="020E0502060401010101" pitchFamily="34" charset="-79"/>
                        </a:rPr>
                        <a:t>Soil_</a:t>
                      </a:r>
                      <a:r>
                        <a:rPr lang="en-US" sz="1200" dirty="0" err="1"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near</a:t>
                      </a:r>
                      <a:r>
                        <a:rPr lang="en-US" sz="1200" dirty="0"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 (ITS)</a:t>
                      </a:r>
                      <a:endParaRPr lang="fr-FR" sz="1200" dirty="0">
                        <a:latin typeface="David" panose="020E0502060401010101" pitchFamily="34" charset="-79"/>
                        <a:cs typeface="David" panose="020E0502060401010101" pitchFamily="34" charset="-79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0.33</a:t>
                      </a:r>
                      <a:endParaRPr lang="fr-FR" sz="1200" dirty="0">
                        <a:latin typeface="David" panose="020E0502060401010101" pitchFamily="34" charset="-79"/>
                        <a:cs typeface="David" panose="020E0502060401010101" pitchFamily="34" charset="-79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43998787"/>
                  </a:ext>
                </a:extLst>
              </a:tr>
            </a:tbl>
          </a:graphicData>
        </a:graphic>
      </p:graphicFrame>
      <p:grpSp>
        <p:nvGrpSpPr>
          <p:cNvPr id="5" name="Group 4">
            <a:extLst>
              <a:ext uri="{FF2B5EF4-FFF2-40B4-BE49-F238E27FC236}">
                <a16:creationId xmlns:a16="http://schemas.microsoft.com/office/drawing/2014/main" id="{28A49F49-DE70-8DD0-A7DC-6648BB7DD20E}"/>
              </a:ext>
            </a:extLst>
          </p:cNvPr>
          <p:cNvGrpSpPr/>
          <p:nvPr/>
        </p:nvGrpSpPr>
        <p:grpSpPr>
          <a:xfrm>
            <a:off x="1734251" y="921462"/>
            <a:ext cx="8170256" cy="5376569"/>
            <a:chOff x="1734251" y="921462"/>
            <a:chExt cx="8170256" cy="5376569"/>
          </a:xfrm>
        </p:grpSpPr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0683B370-06E7-D0B0-DAD4-50AE7EDD2A56}"/>
                </a:ext>
              </a:extLst>
            </p:cNvPr>
            <p:cNvGrpSpPr/>
            <p:nvPr/>
          </p:nvGrpSpPr>
          <p:grpSpPr>
            <a:xfrm>
              <a:off x="1734251" y="921462"/>
              <a:ext cx="8170256" cy="5376569"/>
              <a:chOff x="1734251" y="921462"/>
              <a:chExt cx="8170256" cy="5376569"/>
            </a:xfrm>
          </p:grpSpPr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id="{168E22FA-22DB-9D9C-0A6A-6A946380DC54}"/>
                  </a:ext>
                </a:extLst>
              </p:cNvPr>
              <p:cNvGrpSpPr/>
              <p:nvPr/>
            </p:nvGrpSpPr>
            <p:grpSpPr>
              <a:xfrm>
                <a:off x="1734251" y="921462"/>
                <a:ext cx="6863353" cy="2713384"/>
                <a:chOff x="425395" y="71135"/>
                <a:chExt cx="5202194" cy="2454244"/>
              </a:xfrm>
            </p:grpSpPr>
            <p:pic>
              <p:nvPicPr>
                <p:cNvPr id="9" name="Picture 8">
                  <a:extLst>
                    <a:ext uri="{FF2B5EF4-FFF2-40B4-BE49-F238E27FC236}">
                      <a16:creationId xmlns:a16="http://schemas.microsoft.com/office/drawing/2014/main" id="{C2AC20E5-E028-EA1C-030C-67A936AC05A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68173" y="204825"/>
                  <a:ext cx="2766060" cy="2122170"/>
                </a:xfrm>
                <a:prstGeom prst="rect">
                  <a:avLst/>
                </a:prstGeom>
                <a:noFill/>
              </p:spPr>
            </p:pic>
            <p:sp>
              <p:nvSpPr>
                <p:cNvPr id="11" name="Text Box 8">
                  <a:extLst>
                    <a:ext uri="{FF2B5EF4-FFF2-40B4-BE49-F238E27FC236}">
                      <a16:creationId xmlns:a16="http://schemas.microsoft.com/office/drawing/2014/main" id="{9F4E9FF3-98EF-C54A-71DC-86C2AC41A7E3}"/>
                    </a:ext>
                  </a:extLst>
                </p:cNvPr>
                <p:cNvSpPr txBox="1"/>
                <p:nvPr/>
              </p:nvSpPr>
              <p:spPr>
                <a:xfrm>
                  <a:off x="425395" y="2177399"/>
                  <a:ext cx="245110" cy="347980"/>
                </a:xfrm>
                <a:prstGeom prst="rect">
                  <a:avLst/>
                </a:prstGeom>
                <a:solidFill>
                  <a:schemeClr val="lt1"/>
                </a:solidFill>
                <a:ln w="6350">
                  <a:noFill/>
                </a:ln>
              </p:spPr>
              <p:txBody>
                <a:bodyPr rot="0" spcFirstLastPara="0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1400" b="1" kern="100" dirty="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C </a:t>
                  </a:r>
                  <a:endParaRPr lang="fr-FR" sz="1400" kern="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" name="Text Box 8">
                  <a:extLst>
                    <a:ext uri="{FF2B5EF4-FFF2-40B4-BE49-F238E27FC236}">
                      <a16:creationId xmlns:a16="http://schemas.microsoft.com/office/drawing/2014/main" id="{E4DE58E0-BB1D-38EC-A913-43591E3C9929}"/>
                    </a:ext>
                  </a:extLst>
                </p:cNvPr>
                <p:cNvSpPr txBox="1"/>
                <p:nvPr/>
              </p:nvSpPr>
              <p:spPr>
                <a:xfrm>
                  <a:off x="436418" y="92094"/>
                  <a:ext cx="234087" cy="347980"/>
                </a:xfrm>
                <a:prstGeom prst="rect">
                  <a:avLst/>
                </a:prstGeom>
                <a:solidFill>
                  <a:schemeClr val="lt1"/>
                </a:solidFill>
                <a:ln w="6350">
                  <a:noFill/>
                </a:ln>
              </p:spPr>
              <p:txBody>
                <a:bodyPr rot="0" spcFirstLastPara="0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1400" b="1" kern="100" dirty="0">
                      <a:latin typeface="Calibri" panose="020F050202020403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A</a:t>
                  </a:r>
                  <a:r>
                    <a:rPr lang="en-US" sz="1100" kern="100" dirty="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 </a:t>
                  </a:r>
                  <a:endParaRPr lang="fr-FR" sz="1100" kern="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6" name="Picture 5">
                  <a:extLst>
                    <a:ext uri="{FF2B5EF4-FFF2-40B4-BE49-F238E27FC236}">
                      <a16:creationId xmlns:a16="http://schemas.microsoft.com/office/drawing/2014/main" id="{8D296B0C-0398-2CD3-C1C4-1D12007D126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829774" y="148024"/>
                  <a:ext cx="2797815" cy="2178971"/>
                </a:xfrm>
                <a:prstGeom prst="rect">
                  <a:avLst/>
                </a:prstGeom>
                <a:noFill/>
              </p:spPr>
            </p:pic>
            <p:sp>
              <p:nvSpPr>
                <p:cNvPr id="13" name="Text Box 8">
                  <a:extLst>
                    <a:ext uri="{FF2B5EF4-FFF2-40B4-BE49-F238E27FC236}">
                      <a16:creationId xmlns:a16="http://schemas.microsoft.com/office/drawing/2014/main" id="{1167797A-FD6B-73E1-2408-A4EC922FD8AB}"/>
                    </a:ext>
                  </a:extLst>
                </p:cNvPr>
                <p:cNvSpPr txBox="1"/>
                <p:nvPr/>
              </p:nvSpPr>
              <p:spPr>
                <a:xfrm>
                  <a:off x="2767342" y="71135"/>
                  <a:ext cx="245110" cy="347980"/>
                </a:xfrm>
                <a:prstGeom prst="rect">
                  <a:avLst/>
                </a:prstGeom>
                <a:solidFill>
                  <a:schemeClr val="lt1"/>
                </a:solidFill>
                <a:ln w="6350">
                  <a:noFill/>
                </a:ln>
              </p:spPr>
              <p:txBody>
                <a:bodyPr rot="0" spcFirstLastPara="0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1400" b="1" kern="100" dirty="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B</a:t>
                  </a:r>
                  <a:r>
                    <a:rPr lang="en-US" sz="1100" kern="100" dirty="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 </a:t>
                  </a:r>
                  <a:endParaRPr lang="fr-FR" sz="1100" kern="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" name="Text Box 1">
                <a:extLst>
                  <a:ext uri="{FF2B5EF4-FFF2-40B4-BE49-F238E27FC236}">
                    <a16:creationId xmlns:a16="http://schemas.microsoft.com/office/drawing/2014/main" id="{D49CF04B-36B6-0420-04BA-4046B7EDD629}"/>
                  </a:ext>
                </a:extLst>
              </p:cNvPr>
              <p:cNvSpPr txBox="1"/>
              <p:nvPr/>
            </p:nvSpPr>
            <p:spPr>
              <a:xfrm>
                <a:off x="1790689" y="5761880"/>
                <a:ext cx="8113818" cy="536151"/>
              </a:xfrm>
              <a:prstGeom prst="rect">
                <a:avLst/>
              </a:prstGeom>
              <a:solidFill>
                <a:prstClr val="white"/>
              </a:solidFill>
              <a:ln>
                <a:noFill/>
              </a:ln>
            </p:spPr>
            <p:txBody>
              <a:bodyPr rot="0" spcFirstLastPara="0" vert="horz" wrap="square" lIns="0" tIns="0" rIns="0" bIns="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000"/>
                  </a:spcAft>
                </a:pPr>
                <a:r>
                  <a:rPr lang="en-US" sz="1200" b="1" dirty="0"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Fig. S1. </a:t>
                </a:r>
                <a:r>
                  <a:rPr lang="en-US" sz="1200" dirty="0">
                    <a:solidFill>
                      <a:srgbClr val="44546A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lpha-diversity analysis of soil samples comparing bacterial and fungal communities between two classes (</a:t>
                </a:r>
                <a:r>
                  <a:rPr lang="en-US" sz="1200" dirty="0" err="1">
                    <a:solidFill>
                      <a:srgbClr val="44546A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Soil_far</a:t>
                </a:r>
                <a:r>
                  <a:rPr lang="en-US" sz="1200" dirty="0">
                    <a:solidFill>
                      <a:srgbClr val="44546A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and </a:t>
                </a:r>
                <a:r>
                  <a:rPr lang="en-US" sz="1200" dirty="0" err="1">
                    <a:solidFill>
                      <a:srgbClr val="44546A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Soil_near</a:t>
                </a:r>
                <a:r>
                  <a:rPr lang="en-US" sz="1200" dirty="0">
                    <a:solidFill>
                      <a:srgbClr val="44546A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). (A) 16S rRNA analysis, (B) ITS analysis, (C) pairwise comparisons for 16S and ITS.</a:t>
                </a:r>
                <a:endParaRPr lang="fr-FR" sz="1200" dirty="0">
                  <a:solidFill>
                    <a:srgbClr val="44546A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E466888D-6CC4-ADE2-E027-463D9D874D7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772" t="33319" b="32243"/>
            <a:stretch/>
          </p:blipFill>
          <p:spPr bwMode="auto">
            <a:xfrm>
              <a:off x="7932543" y="1568898"/>
              <a:ext cx="1016172" cy="1252960"/>
            </a:xfrm>
            <a:prstGeom prst="rect">
              <a:avLst/>
            </a:prstGeom>
            <a:noFill/>
          </p:spPr>
        </p:pic>
      </p:grpSp>
    </p:spTree>
    <p:extLst>
      <p:ext uri="{BB962C8B-B14F-4D97-AF65-F5344CB8AC3E}">
        <p14:creationId xmlns:p14="http://schemas.microsoft.com/office/powerpoint/2010/main" val="39116145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1">
            <a:extLst>
              <a:ext uri="{FF2B5EF4-FFF2-40B4-BE49-F238E27FC236}">
                <a16:creationId xmlns:a16="http://schemas.microsoft.com/office/drawing/2014/main" id="{C885B1F4-594F-8A9D-BE74-5D7A0A30123E}"/>
              </a:ext>
            </a:extLst>
          </p:cNvPr>
          <p:cNvSpPr txBox="1"/>
          <p:nvPr/>
        </p:nvSpPr>
        <p:spPr>
          <a:xfrm>
            <a:off x="2619423" y="1154004"/>
            <a:ext cx="6488208" cy="553998"/>
          </a:xfrm>
          <a:prstGeom prst="rect">
            <a:avLst/>
          </a:prstGeom>
          <a:solidFill>
            <a:prstClr val="white"/>
          </a:solidFill>
          <a:ln>
            <a:noFill/>
          </a:ln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b="1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3</a:t>
            </a:r>
          </a:p>
          <a:p>
            <a:pPr>
              <a:spcAft>
                <a:spcPts val="1000"/>
              </a:spcAft>
            </a:pPr>
            <a:r>
              <a:rPr lang="en-US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atistical analysis of alpha and beta diversity for microbial communities. Pairwise analysis of different soil sample locations for (A) 16S rRNA analysis, and (B) ITS analysis. FDR, false discovery rate.</a:t>
            </a:r>
            <a:endParaRPr lang="fr-FR" sz="1200" dirty="0">
              <a:solidFill>
                <a:srgbClr val="44546A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9B0867BF-A13E-F01A-6FC1-BC9E7717BF1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83389125"/>
              </p:ext>
            </p:extLst>
          </p:nvPr>
        </p:nvGraphicFramePr>
        <p:xfrm>
          <a:off x="2635506" y="1862741"/>
          <a:ext cx="5267960" cy="1581849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053465">
                  <a:extLst>
                    <a:ext uri="{9D8B030D-6E8A-4147-A177-3AD203B41FA5}">
                      <a16:colId xmlns:a16="http://schemas.microsoft.com/office/drawing/2014/main" val="178065536"/>
                    </a:ext>
                  </a:extLst>
                </a:gridCol>
                <a:gridCol w="1053465">
                  <a:extLst>
                    <a:ext uri="{9D8B030D-6E8A-4147-A177-3AD203B41FA5}">
                      <a16:colId xmlns:a16="http://schemas.microsoft.com/office/drawing/2014/main" val="1195198861"/>
                    </a:ext>
                  </a:extLst>
                </a:gridCol>
                <a:gridCol w="1053465">
                  <a:extLst>
                    <a:ext uri="{9D8B030D-6E8A-4147-A177-3AD203B41FA5}">
                      <a16:colId xmlns:a16="http://schemas.microsoft.com/office/drawing/2014/main" val="2499788849"/>
                    </a:ext>
                  </a:extLst>
                </a:gridCol>
                <a:gridCol w="1053465">
                  <a:extLst>
                    <a:ext uri="{9D8B030D-6E8A-4147-A177-3AD203B41FA5}">
                      <a16:colId xmlns:a16="http://schemas.microsoft.com/office/drawing/2014/main" val="682711788"/>
                    </a:ext>
                  </a:extLst>
                </a:gridCol>
                <a:gridCol w="1054100">
                  <a:extLst>
                    <a:ext uri="{9D8B030D-6E8A-4147-A177-3AD203B41FA5}">
                      <a16:colId xmlns:a16="http://schemas.microsoft.com/office/drawing/2014/main" val="179633509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16S</a:t>
                      </a:r>
                      <a:endParaRPr lang="fr-FR" sz="1400" b="1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Alpha diversity</a:t>
                      </a:r>
                      <a:endParaRPr lang="fr-FR" sz="1400" b="1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Beta diversity</a:t>
                      </a:r>
                      <a:endParaRPr lang="fr-FR" sz="1400" b="1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366414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pair</a:t>
                      </a:r>
                      <a:endParaRPr lang="fr-FR" sz="1200" b="1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i="1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p</a:t>
                      </a:r>
                      <a:r>
                        <a:rPr lang="en-US" sz="1200" b="1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-value</a:t>
                      </a:r>
                      <a:endParaRPr lang="fr-FR" sz="1200" b="1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FDR</a:t>
                      </a:r>
                      <a:endParaRPr lang="fr-FR" sz="1200" b="1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i="1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p</a:t>
                      </a:r>
                      <a:r>
                        <a:rPr lang="en-US" sz="1200" b="1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-value</a:t>
                      </a:r>
                      <a:endParaRPr lang="fr-FR" sz="1200" b="1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FDR</a:t>
                      </a:r>
                      <a:endParaRPr lang="fr-FR" sz="1200" b="1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307035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Root vs soil far</a:t>
                      </a:r>
                      <a:endParaRPr lang="fr-FR" sz="1200" b="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1.204E-13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1.8606E-13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0.001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0.0015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168339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Root vs soil near</a:t>
                      </a:r>
                      <a:endParaRPr lang="fr-FR" sz="1200" b="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1.204E-13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1.8606E-13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0.001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0.0015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961942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Soil far vs soil near</a:t>
                      </a:r>
                      <a:endParaRPr lang="fr-FR" sz="1200" b="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0.736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0.730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0.111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0.111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3387466"/>
                  </a:ext>
                </a:extLst>
              </a:tr>
            </a:tbl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398E5E19-96D4-1614-042B-9E46F59E8BF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4199957"/>
              </p:ext>
            </p:extLst>
          </p:nvPr>
        </p:nvGraphicFramePr>
        <p:xfrm>
          <a:off x="2635506" y="3599329"/>
          <a:ext cx="5267960" cy="1581849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053465">
                  <a:extLst>
                    <a:ext uri="{9D8B030D-6E8A-4147-A177-3AD203B41FA5}">
                      <a16:colId xmlns:a16="http://schemas.microsoft.com/office/drawing/2014/main" val="751540689"/>
                    </a:ext>
                  </a:extLst>
                </a:gridCol>
                <a:gridCol w="1053465">
                  <a:extLst>
                    <a:ext uri="{9D8B030D-6E8A-4147-A177-3AD203B41FA5}">
                      <a16:colId xmlns:a16="http://schemas.microsoft.com/office/drawing/2014/main" val="843997776"/>
                    </a:ext>
                  </a:extLst>
                </a:gridCol>
                <a:gridCol w="1053465">
                  <a:extLst>
                    <a:ext uri="{9D8B030D-6E8A-4147-A177-3AD203B41FA5}">
                      <a16:colId xmlns:a16="http://schemas.microsoft.com/office/drawing/2014/main" val="2803582793"/>
                    </a:ext>
                  </a:extLst>
                </a:gridCol>
                <a:gridCol w="1053465">
                  <a:extLst>
                    <a:ext uri="{9D8B030D-6E8A-4147-A177-3AD203B41FA5}">
                      <a16:colId xmlns:a16="http://schemas.microsoft.com/office/drawing/2014/main" val="2353681761"/>
                    </a:ext>
                  </a:extLst>
                </a:gridCol>
                <a:gridCol w="1054100">
                  <a:extLst>
                    <a:ext uri="{9D8B030D-6E8A-4147-A177-3AD203B41FA5}">
                      <a16:colId xmlns:a16="http://schemas.microsoft.com/office/drawing/2014/main" val="254045022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ITS</a:t>
                      </a:r>
                      <a:endParaRPr lang="fr-FR" sz="1400" b="1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Alpha diversity</a:t>
                      </a:r>
                      <a:endParaRPr lang="fr-FR" sz="1400" b="1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Beta diversity</a:t>
                      </a:r>
                      <a:endParaRPr lang="fr-FR" sz="1400" b="1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243850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pair</a:t>
                      </a:r>
                      <a:endParaRPr lang="fr-FR" sz="1200" b="1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i="1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p</a:t>
                      </a:r>
                      <a:r>
                        <a:rPr lang="en-US" sz="1200" b="1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-value</a:t>
                      </a:r>
                      <a:endParaRPr lang="fr-FR" sz="1200" b="1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FDR</a:t>
                      </a:r>
                      <a:endParaRPr lang="fr-FR" sz="1200" b="1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i="1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p</a:t>
                      </a:r>
                      <a:r>
                        <a:rPr lang="en-US" sz="1200" b="1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-value</a:t>
                      </a:r>
                      <a:endParaRPr lang="fr-FR" sz="1200" b="1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FDR</a:t>
                      </a:r>
                      <a:endParaRPr lang="fr-FR" sz="1200" b="1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479390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Root vs soil far</a:t>
                      </a:r>
                      <a:endParaRPr lang="fr-FR" sz="1200" b="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0.0016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0.0049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0.001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0.0015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349182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Root vs soil near</a:t>
                      </a:r>
                      <a:endParaRPr lang="fr-FR" sz="1200" b="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0.0067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0.0101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0.001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0.0015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072867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Soil far vs soil near</a:t>
                      </a:r>
                      <a:endParaRPr lang="fr-FR" sz="1200" b="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0.4188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0.4188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0.763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cs typeface="David" panose="020E0502060401010101" pitchFamily="34" charset="-79"/>
                        </a:rPr>
                        <a:t>0.763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87371616"/>
                  </a:ext>
                </a:extLst>
              </a:tr>
            </a:tbl>
          </a:graphicData>
        </a:graphic>
      </p:graphicFrame>
      <p:sp>
        <p:nvSpPr>
          <p:cNvPr id="9" name="Text Box 8">
            <a:extLst>
              <a:ext uri="{FF2B5EF4-FFF2-40B4-BE49-F238E27FC236}">
                <a16:creationId xmlns:a16="http://schemas.microsoft.com/office/drawing/2014/main" id="{D8F0EECD-AE7B-0194-37F2-37A83D447E92}"/>
              </a:ext>
            </a:extLst>
          </p:cNvPr>
          <p:cNvSpPr txBox="1"/>
          <p:nvPr/>
        </p:nvSpPr>
        <p:spPr>
          <a:xfrm>
            <a:off x="2128426" y="1634141"/>
            <a:ext cx="271145" cy="31686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endParaRPr lang="fr-FR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 Box 8">
            <a:extLst>
              <a:ext uri="{FF2B5EF4-FFF2-40B4-BE49-F238E27FC236}">
                <a16:creationId xmlns:a16="http://schemas.microsoft.com/office/drawing/2014/main" id="{DEBC6CC0-14D9-2246-A593-5301BA4A45C7}"/>
              </a:ext>
            </a:extLst>
          </p:cNvPr>
          <p:cNvSpPr txBox="1"/>
          <p:nvPr/>
        </p:nvSpPr>
        <p:spPr>
          <a:xfrm>
            <a:off x="2163635" y="3429000"/>
            <a:ext cx="271145" cy="31686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endParaRPr lang="fr-FR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41008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C0DB1C5-FBB0-04B1-922A-B30AD4476CA1}"/>
              </a:ext>
            </a:extLst>
          </p:cNvPr>
          <p:cNvGrpSpPr/>
          <p:nvPr/>
        </p:nvGrpSpPr>
        <p:grpSpPr>
          <a:xfrm>
            <a:off x="643467" y="1109508"/>
            <a:ext cx="10154073" cy="4329912"/>
            <a:chOff x="0" y="-169247"/>
            <a:chExt cx="5174826" cy="2371040"/>
          </a:xfrm>
        </p:grpSpPr>
        <p:sp>
          <p:nvSpPr>
            <p:cNvPr id="3" name="Text Box 12">
              <a:extLst>
                <a:ext uri="{FF2B5EF4-FFF2-40B4-BE49-F238E27FC236}">
                  <a16:creationId xmlns:a16="http://schemas.microsoft.com/office/drawing/2014/main" id="{5DA15980-EED7-7420-9029-B1A7480B5E8C}"/>
                </a:ext>
              </a:extLst>
            </p:cNvPr>
            <p:cNvSpPr txBox="1">
              <a:spLocks/>
            </p:cNvSpPr>
            <p:nvPr/>
          </p:nvSpPr>
          <p:spPr>
            <a:xfrm>
              <a:off x="0" y="1789043"/>
              <a:ext cx="5174826" cy="412750"/>
            </a:xfrm>
            <a:prstGeom prst="rect">
              <a:avLst/>
            </a:prstGeom>
            <a:solidFill>
              <a:prstClr val="white"/>
            </a:solidFill>
            <a:ln>
              <a:noFill/>
            </a:ln>
          </p:spPr>
          <p:txBody>
            <a:bodyPr rot="0" spcFirstLastPara="0" vert="horz" wrap="square" lIns="0" tIns="0" rIns="0" bIns="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defTabSz="1664208">
                <a:spcAft>
                  <a:spcPts val="1820"/>
                </a:spcAft>
              </a:pPr>
              <a:r>
                <a:rPr lang="en-US" sz="1200" b="1" dirty="0"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Fig.</a:t>
              </a:r>
              <a:r>
                <a:rPr lang="en-US" sz="1200" b="1" kern="1200" dirty="0">
                  <a:solidFill>
                    <a:srgbClr val="FF0000"/>
                  </a:solidFill>
                  <a:latin typeface="Times New Roman" panose="02020603050405020304" pitchFamily="18" charset="0"/>
                </a:rPr>
                <a:t> S2</a:t>
              </a:r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</a:rPr>
                <a:t>. </a:t>
              </a:r>
              <a:r>
                <a:rPr lang="en-US" sz="1200" dirty="0">
                  <a:solidFill>
                    <a:srgbClr val="44546A"/>
                  </a:solidFill>
                  <a:latin typeface="Times New Roman" panose="02020603050405020304" pitchFamily="18" charset="0"/>
                </a:rPr>
                <a:t>Principal coordinates analysis of bacterial 16S rRNA sequences from root (A) and soil (B) samples across different soil ages. Figures present beta diversity of communities based on Bray-Curtis analysis. </a:t>
              </a:r>
              <a:r>
                <a:rPr lang="fr-FR" sz="1200" dirty="0" err="1">
                  <a:solidFill>
                    <a:srgbClr val="44546A"/>
                  </a:solidFill>
                  <a:latin typeface="Times New Roman" panose="02020603050405020304" pitchFamily="18" charset="0"/>
                </a:rPr>
                <a:t>Soil</a:t>
              </a:r>
              <a:r>
                <a:rPr lang="fr-FR" sz="1200" dirty="0">
                  <a:solidFill>
                    <a:srgbClr val="44546A"/>
                  </a:solidFill>
                  <a:latin typeface="Times New Roman" panose="02020603050405020304" pitchFamily="18" charset="0"/>
                </a:rPr>
                <a:t> </a:t>
              </a:r>
              <a:r>
                <a:rPr lang="fr-FR" sz="1200" dirty="0" err="1">
                  <a:solidFill>
                    <a:srgbClr val="44546A"/>
                  </a:solidFill>
                  <a:latin typeface="Times New Roman" panose="02020603050405020304" pitchFamily="18" charset="0"/>
                </a:rPr>
                <a:t>ages</a:t>
              </a:r>
              <a:r>
                <a:rPr lang="fr-FR" sz="1200" dirty="0">
                  <a:solidFill>
                    <a:srgbClr val="44546A"/>
                  </a:solidFill>
                  <a:latin typeface="Times New Roman" panose="02020603050405020304" pitchFamily="18" charset="0"/>
                </a:rPr>
                <a:t> are </a:t>
              </a:r>
              <a:r>
                <a:rPr lang="fr-FR" sz="1200" dirty="0" err="1">
                  <a:solidFill>
                    <a:srgbClr val="44546A"/>
                  </a:solidFill>
                  <a:latin typeface="Times New Roman" panose="02020603050405020304" pitchFamily="18" charset="0"/>
                </a:rPr>
                <a:t>indicated</a:t>
              </a:r>
              <a:r>
                <a:rPr lang="fr-FR" sz="1200" dirty="0">
                  <a:solidFill>
                    <a:srgbClr val="44546A"/>
                  </a:solidFill>
                  <a:latin typeface="Times New Roman" panose="02020603050405020304" pitchFamily="18" charset="0"/>
                </a:rPr>
                <a:t> by </a:t>
              </a:r>
              <a:r>
                <a:rPr lang="fr-FR" sz="1200" dirty="0" err="1">
                  <a:solidFill>
                    <a:srgbClr val="44546A"/>
                  </a:solidFill>
                  <a:latin typeface="Times New Roman" panose="02020603050405020304" pitchFamily="18" charset="0"/>
                </a:rPr>
                <a:t>different</a:t>
              </a:r>
              <a:r>
                <a:rPr lang="fr-FR" sz="1200" dirty="0">
                  <a:solidFill>
                    <a:srgbClr val="44546A"/>
                  </a:solidFill>
                  <a:latin typeface="Times New Roman" panose="02020603050405020304" pitchFamily="18" charset="0"/>
                </a:rPr>
                <a:t> </a:t>
              </a:r>
              <a:r>
                <a:rPr lang="fr-FR" sz="1200" dirty="0" err="1">
                  <a:solidFill>
                    <a:srgbClr val="44546A"/>
                  </a:solidFill>
                  <a:latin typeface="Times New Roman" panose="02020603050405020304" pitchFamily="18" charset="0"/>
                </a:rPr>
                <a:t>colors</a:t>
              </a:r>
              <a:r>
                <a:rPr lang="fr-FR" sz="1200" dirty="0">
                  <a:solidFill>
                    <a:srgbClr val="44546A"/>
                  </a:solidFill>
                  <a:latin typeface="Times New Roman" panose="02020603050405020304" pitchFamily="18" charset="0"/>
                </a:rPr>
                <a:t>.</a:t>
              </a:r>
            </a:p>
          </p:txBody>
        </p: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AC6E8F7C-C0B1-E29D-ECF4-E1EBC95F4A4E}"/>
                </a:ext>
              </a:extLst>
            </p:cNvPr>
            <p:cNvGrpSpPr>
              <a:grpSpLocks/>
            </p:cNvGrpSpPr>
            <p:nvPr/>
          </p:nvGrpSpPr>
          <p:grpSpPr>
            <a:xfrm>
              <a:off x="154921" y="-169247"/>
              <a:ext cx="2801567" cy="338493"/>
              <a:chOff x="159177" y="-197695"/>
              <a:chExt cx="2878541" cy="395389"/>
            </a:xfrm>
          </p:grpSpPr>
          <p:sp>
            <p:nvSpPr>
              <p:cNvPr id="8" name="Text Box 24">
                <a:extLst>
                  <a:ext uri="{FF2B5EF4-FFF2-40B4-BE49-F238E27FC236}">
                    <a16:creationId xmlns:a16="http://schemas.microsoft.com/office/drawing/2014/main" id="{34FD9C7E-DA83-AD3B-F771-E91E08ED155A}"/>
                  </a:ext>
                </a:extLst>
              </p:cNvPr>
              <p:cNvSpPr txBox="1"/>
              <p:nvPr/>
            </p:nvSpPr>
            <p:spPr>
              <a:xfrm>
                <a:off x="159177" y="-182117"/>
                <a:ext cx="261687" cy="364233"/>
              </a:xfrm>
              <a:prstGeom prst="rect">
                <a:avLst/>
              </a:prstGeom>
              <a:solidFill>
                <a:schemeClr val="lt1"/>
              </a:solidFill>
              <a:ln w="6350">
                <a:noFill/>
              </a:ln>
            </p:spPr>
            <p:txBody>
              <a:bodyPr rot="0" spcFirstLastPara="0" vert="horz" wrap="non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defTabSz="1664208">
                  <a:spcAft>
                    <a:spcPts val="600"/>
                  </a:spcAft>
                </a:pPr>
                <a:r>
                  <a:rPr lang="fr-FR" sz="1400" b="1" kern="1200" dirty="0">
                    <a:solidFill>
                      <a:schemeClr val="tx1"/>
                    </a:solidFill>
                    <a:latin typeface="Calibri" panose="020F0502020204030204" pitchFamily="34" charset="0"/>
                    <a:ea typeface="+mn-ea"/>
                    <a:cs typeface="+mn-cs"/>
                  </a:rPr>
                  <a:t>A</a:t>
                </a:r>
                <a:endParaRPr lang="fr-FR" sz="9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9" name="Text Box 24">
                <a:extLst>
                  <a:ext uri="{FF2B5EF4-FFF2-40B4-BE49-F238E27FC236}">
                    <a16:creationId xmlns:a16="http://schemas.microsoft.com/office/drawing/2014/main" id="{DDDC95BE-0C54-05CC-078E-B6395A763B4D}"/>
                  </a:ext>
                </a:extLst>
              </p:cNvPr>
              <p:cNvSpPr txBox="1"/>
              <p:nvPr/>
            </p:nvSpPr>
            <p:spPr>
              <a:xfrm>
                <a:off x="2778405" y="-197695"/>
                <a:ext cx="259313" cy="395389"/>
              </a:xfrm>
              <a:prstGeom prst="rect">
                <a:avLst/>
              </a:prstGeom>
              <a:solidFill>
                <a:schemeClr val="lt1"/>
              </a:solidFill>
              <a:ln w="6350">
                <a:noFill/>
              </a:ln>
            </p:spPr>
            <p:txBody>
              <a:bodyPr rot="0" spcFirstLastPara="0" vert="horz" wrap="non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defTabSz="1664208">
                  <a:spcAft>
                    <a:spcPts val="600"/>
                  </a:spcAft>
                </a:pPr>
                <a:r>
                  <a:rPr lang="fr-FR" sz="1400" b="1" kern="1200" dirty="0">
                    <a:solidFill>
                      <a:schemeClr val="tx1"/>
                    </a:solidFill>
                    <a:latin typeface="Calibri" panose="020F0502020204030204" pitchFamily="34" charset="0"/>
                    <a:ea typeface="+mn-ea"/>
                    <a:cs typeface="+mn-cs"/>
                  </a:rPr>
                  <a:t>B</a:t>
                </a:r>
                <a:endParaRPr lang="fr-FR" sz="9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</p:grpSp>
      </p:grpSp>
      <p:pic>
        <p:nvPicPr>
          <p:cNvPr id="6" name="Picture 5" descr="A graph with many colored dots&#10;&#10;Description automatically generated">
            <a:extLst>
              <a:ext uri="{FF2B5EF4-FFF2-40B4-BE49-F238E27FC236}">
                <a16:creationId xmlns:a16="http://schemas.microsoft.com/office/drawing/2014/main" id="{278D1FC8-92DD-4A55-B2D7-E623DB8CE3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91659" y="1447428"/>
            <a:ext cx="4228844" cy="2938166"/>
          </a:xfrm>
          <a:prstGeom prst="rect">
            <a:avLst/>
          </a:prstGeom>
        </p:spPr>
      </p:pic>
      <p:pic>
        <p:nvPicPr>
          <p:cNvPr id="12" name="Picture 11" descr="A graph with many colored dots&#10;&#10;Description automatically generated">
            <a:extLst>
              <a:ext uri="{FF2B5EF4-FFF2-40B4-BE49-F238E27FC236}">
                <a16:creationId xmlns:a16="http://schemas.microsoft.com/office/drawing/2014/main" id="{7851E2FB-2ABE-8D78-F239-938AE13082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09161" y="1364520"/>
            <a:ext cx="4348172" cy="30210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43947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9F0F54A3-C520-7A8A-E118-A14FAEF3D91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71325162"/>
              </p:ext>
            </p:extLst>
          </p:nvPr>
        </p:nvGraphicFramePr>
        <p:xfrm>
          <a:off x="1765461" y="2023961"/>
          <a:ext cx="2019300" cy="3915590"/>
        </p:xfrm>
        <a:graphic>
          <a:graphicData uri="http://schemas.openxmlformats.org/drawingml/2006/table">
            <a:tbl>
              <a:tblPr firstRow="1" firstCol="1" bandRow="1"/>
              <a:tblGrid>
                <a:gridCol w="1227232">
                  <a:extLst>
                    <a:ext uri="{9D8B030D-6E8A-4147-A177-3AD203B41FA5}">
                      <a16:colId xmlns:a16="http://schemas.microsoft.com/office/drawing/2014/main" val="3708858377"/>
                    </a:ext>
                  </a:extLst>
                </a:gridCol>
                <a:gridCol w="792068">
                  <a:extLst>
                    <a:ext uri="{9D8B030D-6E8A-4147-A177-3AD203B41FA5}">
                      <a16:colId xmlns:a16="http://schemas.microsoft.com/office/drawing/2014/main" val="4282106780"/>
                    </a:ext>
                  </a:extLst>
                </a:gridCol>
              </a:tblGrid>
              <a:tr h="22748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ir</a:t>
                      </a:r>
                      <a:endParaRPr lang="fr-FR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DR</a:t>
                      </a:r>
                      <a:endParaRPr lang="fr-FR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22279138"/>
                  </a:ext>
                </a:extLst>
              </a:tr>
              <a:tr h="22748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 dirty="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6 vs 0</a:t>
                      </a:r>
                      <a:endParaRPr lang="fr-FR" sz="1200" b="1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08</a:t>
                      </a:r>
                      <a:endParaRPr lang="fr-FR" sz="1200" kern="10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4581622"/>
                  </a:ext>
                </a:extLst>
              </a:tr>
              <a:tr h="22748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 dirty="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36 vs 18</a:t>
                      </a:r>
                      <a:endParaRPr lang="fr-FR" sz="1200" b="1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08</a:t>
                      </a:r>
                      <a:endParaRPr lang="fr-FR" sz="1200" kern="10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7918841"/>
                  </a:ext>
                </a:extLst>
              </a:tr>
              <a:tr h="22748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30 vs 6</a:t>
                      </a:r>
                      <a:endParaRPr lang="fr-FR" sz="1200" b="1" kern="10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08</a:t>
                      </a:r>
                      <a:endParaRPr lang="fr-FR" sz="1200" kern="10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29260391"/>
                  </a:ext>
                </a:extLst>
              </a:tr>
              <a:tr h="22748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30 vs 0</a:t>
                      </a:r>
                      <a:endParaRPr lang="fr-FR" sz="1200" b="1" kern="10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08</a:t>
                      </a:r>
                      <a:endParaRPr lang="fr-FR" sz="1200" kern="10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7364209"/>
                  </a:ext>
                </a:extLst>
              </a:tr>
              <a:tr h="22748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18 vs 6</a:t>
                      </a:r>
                      <a:endParaRPr lang="fr-FR" sz="1200" b="1" kern="10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08</a:t>
                      </a:r>
                      <a:endParaRPr lang="fr-FR" sz="1200" kern="10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7332856"/>
                  </a:ext>
                </a:extLst>
              </a:tr>
              <a:tr h="22748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18 vs 0</a:t>
                      </a:r>
                      <a:endParaRPr lang="fr-FR" sz="1200" b="1" kern="10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08</a:t>
                      </a:r>
                      <a:endParaRPr lang="fr-FR" sz="1200" kern="10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7568150"/>
                  </a:ext>
                </a:extLst>
              </a:tr>
              <a:tr h="22748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12 vs 0</a:t>
                      </a:r>
                      <a:endParaRPr lang="fr-FR" sz="1200" b="1" kern="10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08</a:t>
                      </a:r>
                      <a:endParaRPr lang="fr-FR" sz="1200" kern="10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02744934"/>
                  </a:ext>
                </a:extLst>
              </a:tr>
              <a:tr h="22748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42 vs 6</a:t>
                      </a:r>
                      <a:endParaRPr lang="fr-FR" sz="1200" b="1" kern="10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08</a:t>
                      </a:r>
                      <a:endParaRPr lang="fr-FR" sz="120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6228901"/>
                  </a:ext>
                </a:extLst>
              </a:tr>
              <a:tr h="20867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36 vs 0</a:t>
                      </a:r>
                      <a:endParaRPr lang="fr-FR" sz="1200" b="1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08</a:t>
                      </a:r>
                      <a:endParaRPr lang="fr-FR" sz="120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1424430"/>
                  </a:ext>
                </a:extLst>
              </a:tr>
              <a:tr h="22748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24 vs 0</a:t>
                      </a:r>
                      <a:endParaRPr lang="fr-FR" sz="1200" b="1" kern="10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08</a:t>
                      </a:r>
                      <a:endParaRPr lang="fr-FR" sz="120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7809193"/>
                  </a:ext>
                </a:extLst>
              </a:tr>
              <a:tr h="22748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42 vs 0</a:t>
                      </a:r>
                      <a:endParaRPr lang="fr-FR" sz="1200" b="1" kern="10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09</a:t>
                      </a:r>
                      <a:endParaRPr lang="fr-FR" sz="120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8916751"/>
                  </a:ext>
                </a:extLst>
              </a:tr>
              <a:tr h="22748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36 vs 12</a:t>
                      </a:r>
                      <a:endParaRPr lang="fr-FR" sz="1200" b="1" kern="10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09</a:t>
                      </a:r>
                      <a:endParaRPr lang="fr-FR" sz="120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3690244"/>
                  </a:ext>
                </a:extLst>
              </a:tr>
              <a:tr h="22748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30 vs 18</a:t>
                      </a:r>
                      <a:endParaRPr lang="fr-FR" sz="1200" b="1" kern="10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09</a:t>
                      </a:r>
                      <a:endParaRPr lang="fr-FR" sz="120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2575986"/>
                  </a:ext>
                </a:extLst>
              </a:tr>
              <a:tr h="22748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30 vs 12</a:t>
                      </a:r>
                      <a:endParaRPr lang="fr-FR" sz="1200" b="1" kern="10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09</a:t>
                      </a:r>
                      <a:endParaRPr lang="fr-FR" sz="120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62095660"/>
                  </a:ext>
                </a:extLst>
              </a:tr>
              <a:tr h="25808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 dirty="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24 vs 6</a:t>
                      </a:r>
                      <a:endParaRPr lang="fr-FR" sz="1200" b="1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09</a:t>
                      </a:r>
                      <a:endParaRPr lang="fr-FR" sz="1200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84295260"/>
                  </a:ext>
                </a:extLst>
              </a:tr>
              <a:tr h="2640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 dirty="0"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12 vs 6</a:t>
                      </a:r>
                      <a:endParaRPr lang="fr-FR" sz="1200" b="1" kern="100" dirty="0"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09</a:t>
                      </a:r>
                      <a:endParaRPr lang="fr-FR" sz="120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50687266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9F27AF73-649B-8F80-0509-6CE220A036F9}"/>
              </a:ext>
            </a:extLst>
          </p:cNvPr>
          <p:cNvSpPr txBox="1"/>
          <p:nvPr/>
        </p:nvSpPr>
        <p:spPr>
          <a:xfrm>
            <a:off x="838365" y="709056"/>
            <a:ext cx="9121165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lang="en-US" sz="1200" b="1" dirty="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4 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hylogenetic relationships between microbial communities from soil samples of various ages. Pairwise PERMANOVA for 16S rRNA. </a:t>
            </a:r>
            <a:r>
              <a:rPr lang="en-US" sz="1200" dirty="0" err="1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ultitest</a:t>
            </a:r>
            <a:r>
              <a:rPr lang="en-US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djustment based on </a:t>
            </a:r>
            <a:r>
              <a:rPr lang="en-US" sz="1200" dirty="0" err="1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enjamini</a:t>
            </a:r>
            <a:r>
              <a:rPr lang="en-US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Hochberg procedure (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alse </a:t>
            </a:r>
            <a:r>
              <a:rPr lang="fr-FR" sz="1200" dirty="0" err="1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scovery</a:t>
            </a:r>
            <a:r>
              <a:rPr lang="fr-FR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ate, </a:t>
            </a:r>
            <a:r>
              <a:rPr lang="en-US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DR). Comparisons with (A) statistically significant adjusted p-values </a:t>
            </a:r>
            <a:r>
              <a:rPr lang="fr-FR" altLang="fr-FR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q &lt; 0.005) and (B) </a:t>
            </a:r>
            <a:r>
              <a:rPr lang="en-US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n-significant adjusted p-values</a:t>
            </a:r>
            <a:r>
              <a:rPr lang="fr-FR" altLang="fr-FR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q ≥ 0.005). 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DAFD32AB-A980-AB05-9C00-10E44A027A2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4103928"/>
              </p:ext>
            </p:extLst>
          </p:nvPr>
        </p:nvGraphicFramePr>
        <p:xfrm>
          <a:off x="4497805" y="2019077"/>
          <a:ext cx="1638300" cy="3920475"/>
        </p:xfrm>
        <a:graphic>
          <a:graphicData uri="http://schemas.openxmlformats.org/drawingml/2006/table">
            <a:tbl>
              <a:tblPr firstRow="1" firstCol="1" bandRow="1"/>
              <a:tblGrid>
                <a:gridCol w="980146">
                  <a:extLst>
                    <a:ext uri="{9D8B030D-6E8A-4147-A177-3AD203B41FA5}">
                      <a16:colId xmlns:a16="http://schemas.microsoft.com/office/drawing/2014/main" val="3708858377"/>
                    </a:ext>
                  </a:extLst>
                </a:gridCol>
                <a:gridCol w="658154">
                  <a:extLst>
                    <a:ext uri="{9D8B030D-6E8A-4147-A177-3AD203B41FA5}">
                      <a16:colId xmlns:a16="http://schemas.microsoft.com/office/drawing/2014/main" val="4282106780"/>
                    </a:ext>
                  </a:extLst>
                </a:gridCol>
              </a:tblGrid>
              <a:tr h="29717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ir</a:t>
                      </a:r>
                      <a:endParaRPr lang="fr-FR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DR</a:t>
                      </a:r>
                      <a:endParaRPr lang="fr-FR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84" marR="5148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22279138"/>
                  </a:ext>
                </a:extLst>
              </a:tr>
              <a:tr h="297176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30 vs 2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319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4581622"/>
                  </a:ext>
                </a:extLst>
              </a:tr>
              <a:tr h="297176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42 vs 30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257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7918841"/>
                  </a:ext>
                </a:extLst>
              </a:tr>
              <a:tr h="297176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42 vs 2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257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29260391"/>
                  </a:ext>
                </a:extLst>
              </a:tr>
              <a:tr h="297176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24 vs 18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212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7364209"/>
                  </a:ext>
                </a:extLst>
              </a:tr>
              <a:tr h="297176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36 vs 30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13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7332856"/>
                  </a:ext>
                </a:extLst>
              </a:tr>
              <a:tr h="297176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42 vs 36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123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02744934"/>
                  </a:ext>
                </a:extLst>
              </a:tr>
              <a:tr h="297176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42 vs 12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123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6228901"/>
                  </a:ext>
                </a:extLst>
              </a:tr>
              <a:tr h="272603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36 vs 2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123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1424430"/>
                  </a:ext>
                </a:extLst>
              </a:tr>
              <a:tr h="297176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24 vs 12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123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7809193"/>
                  </a:ext>
                </a:extLst>
              </a:tr>
              <a:tr h="297176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42 vs 18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99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8916751"/>
                  </a:ext>
                </a:extLst>
              </a:tr>
              <a:tr h="338056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18 vs 12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95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27701926"/>
                  </a:ext>
                </a:extLst>
              </a:tr>
              <a:tr h="338056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36 vs 6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13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3690244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EB71925A-0384-8ADA-AC1A-D28C9EEA2A2A}"/>
              </a:ext>
            </a:extLst>
          </p:cNvPr>
          <p:cNvSpPr txBox="1"/>
          <p:nvPr/>
        </p:nvSpPr>
        <p:spPr>
          <a:xfrm>
            <a:off x="1408635" y="1844853"/>
            <a:ext cx="293670" cy="3126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kern="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endParaRPr lang="fr-FR" sz="1400" b="1" kern="1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E29BBB3-8E80-22A3-5F15-B226DD42EC20}"/>
              </a:ext>
            </a:extLst>
          </p:cNvPr>
          <p:cNvSpPr txBox="1"/>
          <p:nvPr/>
        </p:nvSpPr>
        <p:spPr>
          <a:xfrm>
            <a:off x="4132193" y="1844853"/>
            <a:ext cx="293670" cy="3126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kern="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endParaRPr lang="fr-FR" sz="1400" b="1" kern="1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072880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F27AF73-649B-8F80-0509-6CE220A036F9}"/>
              </a:ext>
            </a:extLst>
          </p:cNvPr>
          <p:cNvSpPr txBox="1"/>
          <p:nvPr/>
        </p:nvSpPr>
        <p:spPr>
          <a:xfrm>
            <a:off x="1693781" y="940710"/>
            <a:ext cx="7047096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5</a:t>
            </a:r>
          </a:p>
          <a:p>
            <a:pPr>
              <a:spcAft>
                <a:spcPts val="1000"/>
              </a:spcAft>
            </a:pPr>
            <a:r>
              <a:rPr lang="en-US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gnificant phylogenetic relationships between microbial communities from soil samples of various ages. Pairwise PERMANOVA for ITS sequences. </a:t>
            </a:r>
            <a:r>
              <a:rPr lang="en-US" sz="1200" dirty="0" err="1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ultitest</a:t>
            </a:r>
            <a:r>
              <a:rPr lang="en-US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djustment based on </a:t>
            </a:r>
            <a:r>
              <a:rPr lang="en-US" sz="1200" dirty="0" err="1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enjamini</a:t>
            </a:r>
            <a:r>
              <a:rPr lang="en-US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Hochberg procedure (false discovery rate, FDR). Table presents only comparisons with statistically significant adjusted p-values </a:t>
            </a:r>
            <a:r>
              <a:rPr lang="fr-FR" altLang="fr-FR" sz="1200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q &lt; 0.005).</a:t>
            </a:r>
            <a:endParaRPr lang="fr-FR" sz="1200" dirty="0">
              <a:solidFill>
                <a:srgbClr val="44546A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FC95DFE8-5295-6ACE-BDAE-B177049E2D6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99896257"/>
              </p:ext>
            </p:extLst>
          </p:nvPr>
        </p:nvGraphicFramePr>
        <p:xfrm>
          <a:off x="1814088" y="2151308"/>
          <a:ext cx="1524000" cy="3046701"/>
        </p:xfrm>
        <a:graphic>
          <a:graphicData uri="http://schemas.openxmlformats.org/drawingml/2006/table">
            <a:tbl>
              <a:tblPr firstRow="1" firstCol="1" bandRow="1"/>
              <a:tblGrid>
                <a:gridCol w="1046090">
                  <a:extLst>
                    <a:ext uri="{9D8B030D-6E8A-4147-A177-3AD203B41FA5}">
                      <a16:colId xmlns:a16="http://schemas.microsoft.com/office/drawing/2014/main" val="1505713056"/>
                    </a:ext>
                  </a:extLst>
                </a:gridCol>
                <a:gridCol w="477910">
                  <a:extLst>
                    <a:ext uri="{9D8B030D-6E8A-4147-A177-3AD203B41FA5}">
                      <a16:colId xmlns:a16="http://schemas.microsoft.com/office/drawing/2014/main" val="1007022208"/>
                    </a:ext>
                  </a:extLst>
                </a:gridCol>
              </a:tblGrid>
              <a:tr h="297823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ir</a:t>
                      </a:r>
                      <a:endParaRPr lang="fr-FR" sz="1200" b="1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DR</a:t>
                      </a:r>
                      <a:endParaRPr lang="fr-FR" sz="1200" b="1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94010214"/>
                  </a:ext>
                </a:extLst>
              </a:tr>
              <a:tr h="297823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36 vs 0</a:t>
                      </a:r>
                      <a:endParaRPr lang="fr-FR" sz="1200" b="0" kern="10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17</a:t>
                      </a:r>
                      <a:endParaRPr lang="fr-FR" sz="1200" b="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9705375"/>
                  </a:ext>
                </a:extLst>
              </a:tr>
              <a:tr h="297823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30 vs 0</a:t>
                      </a:r>
                      <a:endParaRPr lang="fr-FR" sz="1200" b="0" kern="10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17</a:t>
                      </a:r>
                      <a:endParaRPr lang="fr-FR" sz="1200" b="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27907"/>
                  </a:ext>
                </a:extLst>
              </a:tr>
              <a:tr h="297823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24 vs 0</a:t>
                      </a:r>
                      <a:endParaRPr lang="fr-FR" sz="1200" b="0" kern="10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17</a:t>
                      </a:r>
                      <a:endParaRPr lang="fr-FR" sz="1200" b="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2948207"/>
                  </a:ext>
                </a:extLst>
              </a:tr>
              <a:tr h="297823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18 vs 0</a:t>
                      </a:r>
                      <a:endParaRPr lang="fr-FR" sz="1200" b="0" kern="10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17</a:t>
                      </a:r>
                      <a:endParaRPr lang="fr-FR" sz="1200" b="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51405232"/>
                  </a:ext>
                </a:extLst>
              </a:tr>
              <a:tr h="297823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12 vs 0</a:t>
                      </a:r>
                      <a:endParaRPr lang="fr-FR" sz="1200" b="0" kern="10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17</a:t>
                      </a:r>
                      <a:endParaRPr lang="fr-FR" sz="1200" b="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89792546"/>
                  </a:ext>
                </a:extLst>
              </a:tr>
              <a:tr h="338205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42 vs 0</a:t>
                      </a:r>
                      <a:endParaRPr lang="fr-FR" sz="1200" b="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23</a:t>
                      </a:r>
                      <a:endParaRPr lang="fr-FR" sz="1200" b="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9576358"/>
                  </a:ext>
                </a:extLst>
              </a:tr>
              <a:tr h="297823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6 vs 0</a:t>
                      </a:r>
                      <a:endParaRPr lang="fr-FR" sz="1200" b="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24</a:t>
                      </a:r>
                      <a:endParaRPr lang="fr-FR" sz="1200" b="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7905020"/>
                  </a:ext>
                </a:extLst>
              </a:tr>
              <a:tr h="308731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36 vs 12</a:t>
                      </a:r>
                      <a:endParaRPr lang="fr-FR" sz="1200" b="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31</a:t>
                      </a:r>
                      <a:endParaRPr lang="fr-FR" sz="1200" b="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4415260"/>
                  </a:ext>
                </a:extLst>
              </a:tr>
              <a:tr h="315004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36 vs 18</a:t>
                      </a:r>
                      <a:endParaRPr lang="fr-FR" sz="1200" b="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David" panose="020E0502060401010101" pitchFamily="34" charset="-79"/>
                          <a:ea typeface="Calibri" panose="020F0502020204030204" pitchFamily="34" charset="0"/>
                          <a:cs typeface="David" panose="020E0502060401010101" pitchFamily="34" charset="-79"/>
                        </a:rPr>
                        <a:t>0.046</a:t>
                      </a:r>
                      <a:endParaRPr lang="fr-FR" sz="1200" b="0" kern="100" dirty="0">
                        <a:solidFill>
                          <a:schemeClr val="tx1"/>
                        </a:solidFill>
                        <a:effectLst/>
                        <a:latin typeface="David" panose="020E0502060401010101" pitchFamily="34" charset="-79"/>
                        <a:ea typeface="Calibri" panose="020F0502020204030204" pitchFamily="34" charset="0"/>
                        <a:cs typeface="David" panose="020E0502060401010101" pitchFamily="34" charset="-79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0962887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4065790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50EDFD51-74AF-F959-D324-C8F6BE77B0F3}"/>
              </a:ext>
            </a:extLst>
          </p:cNvPr>
          <p:cNvGrpSpPr/>
          <p:nvPr/>
        </p:nvGrpSpPr>
        <p:grpSpPr>
          <a:xfrm>
            <a:off x="716679" y="1172340"/>
            <a:ext cx="10831854" cy="4620349"/>
            <a:chOff x="39756" y="60290"/>
            <a:chExt cx="5882005" cy="2602679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5F962F6F-1193-E728-ECC9-822646A20A9A}"/>
                </a:ext>
              </a:extLst>
            </p:cNvPr>
            <p:cNvGrpSpPr>
              <a:grpSpLocks/>
            </p:cNvGrpSpPr>
            <p:nvPr/>
          </p:nvGrpSpPr>
          <p:grpSpPr>
            <a:xfrm>
              <a:off x="90435" y="60290"/>
              <a:ext cx="2854206" cy="281661"/>
              <a:chOff x="90435" y="60290"/>
              <a:chExt cx="2854206" cy="281661"/>
            </a:xfrm>
          </p:grpSpPr>
          <p:sp>
            <p:nvSpPr>
              <p:cNvPr id="8" name="Text Box 24">
                <a:extLst>
                  <a:ext uri="{FF2B5EF4-FFF2-40B4-BE49-F238E27FC236}">
                    <a16:creationId xmlns:a16="http://schemas.microsoft.com/office/drawing/2014/main" id="{06545557-8460-9007-2D82-2BEAF1257D37}"/>
                  </a:ext>
                </a:extLst>
              </p:cNvPr>
              <p:cNvSpPr txBox="1"/>
              <p:nvPr/>
            </p:nvSpPr>
            <p:spPr>
              <a:xfrm>
                <a:off x="90435" y="85411"/>
                <a:ext cx="276860" cy="256540"/>
              </a:xfrm>
              <a:prstGeom prst="rect">
                <a:avLst/>
              </a:prstGeom>
              <a:solidFill>
                <a:schemeClr val="lt1"/>
              </a:solidFill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defTabSz="1691640">
                  <a:spcAft>
                    <a:spcPts val="600"/>
                  </a:spcAft>
                </a:pPr>
                <a:r>
                  <a:rPr lang="fr-FR" sz="2220" b="1" kern="1200">
                    <a:solidFill>
                      <a:schemeClr val="tx1"/>
                    </a:solidFill>
                    <a:latin typeface="Calibri" panose="020F0502020204030204" pitchFamily="34" charset="0"/>
                    <a:ea typeface="+mn-ea"/>
                    <a:cs typeface="+mn-cs"/>
                  </a:rPr>
                  <a:t>A</a:t>
                </a:r>
                <a:endParaRPr lang="fr-FR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9" name="Text Box 24">
                <a:extLst>
                  <a:ext uri="{FF2B5EF4-FFF2-40B4-BE49-F238E27FC236}">
                    <a16:creationId xmlns:a16="http://schemas.microsoft.com/office/drawing/2014/main" id="{D4A1210C-8A44-0D03-2853-FBAA4CA6980E}"/>
                  </a:ext>
                </a:extLst>
              </p:cNvPr>
              <p:cNvSpPr txBox="1"/>
              <p:nvPr/>
            </p:nvSpPr>
            <p:spPr>
              <a:xfrm>
                <a:off x="2672861" y="60290"/>
                <a:ext cx="271780" cy="256540"/>
              </a:xfrm>
              <a:prstGeom prst="rect">
                <a:avLst/>
              </a:prstGeom>
              <a:solidFill>
                <a:schemeClr val="lt1"/>
              </a:solidFill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defTabSz="1691640">
                  <a:spcAft>
                    <a:spcPts val="600"/>
                  </a:spcAft>
                </a:pPr>
                <a:r>
                  <a:rPr lang="fr-FR" sz="2220" b="1" kern="1200">
                    <a:solidFill>
                      <a:schemeClr val="tx1"/>
                    </a:solidFill>
                    <a:latin typeface="Calibri" panose="020F0502020204030204" pitchFamily="34" charset="0"/>
                    <a:ea typeface="+mn-ea"/>
                    <a:cs typeface="+mn-cs"/>
                  </a:rPr>
                  <a:t>B</a:t>
                </a:r>
                <a:endParaRPr lang="fr-FR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</p:grpSp>
        <p:sp>
          <p:nvSpPr>
            <p:cNvPr id="4" name="Text Box 11">
              <a:extLst>
                <a:ext uri="{FF2B5EF4-FFF2-40B4-BE49-F238E27FC236}">
                  <a16:creationId xmlns:a16="http://schemas.microsoft.com/office/drawing/2014/main" id="{5EB265D6-94FF-6DED-3A6C-C237A9216EEA}"/>
                </a:ext>
              </a:extLst>
            </p:cNvPr>
            <p:cNvSpPr txBox="1">
              <a:spLocks/>
            </p:cNvSpPr>
            <p:nvPr/>
          </p:nvSpPr>
          <p:spPr>
            <a:xfrm>
              <a:off x="39756" y="2250219"/>
              <a:ext cx="5882005" cy="412750"/>
            </a:xfrm>
            <a:prstGeom prst="rect">
              <a:avLst/>
            </a:prstGeom>
            <a:solidFill>
              <a:prstClr val="white"/>
            </a:solidFill>
            <a:ln>
              <a:noFill/>
            </a:ln>
          </p:spPr>
          <p:txBody>
            <a:bodyPr rot="0" spcFirstLastPara="0" vert="horz" wrap="square" lIns="0" tIns="0" rIns="0" bIns="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defTabSz="1664208">
                <a:spcAft>
                  <a:spcPts val="1820"/>
                </a:spcAft>
              </a:pPr>
              <a:r>
                <a:rPr lang="en-US" sz="1200" b="1" dirty="0"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Fig. S</a:t>
              </a:r>
              <a:r>
                <a:rPr lang="en-US" sz="1200" b="1" kern="1200" dirty="0">
                  <a:solidFill>
                    <a:srgbClr val="FF0000"/>
                  </a:solidFill>
                  <a:latin typeface="Times New Roman" panose="02020603050405020304" pitchFamily="18" charset="0"/>
                </a:rPr>
                <a:t>3. </a:t>
              </a:r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</a:rPr>
                <a:t> </a:t>
              </a:r>
              <a:r>
                <a:rPr lang="en-US" sz="1200" dirty="0">
                  <a:solidFill>
                    <a:srgbClr val="44546A"/>
                  </a:solidFill>
                  <a:latin typeface="Times New Roman" panose="02020603050405020304" pitchFamily="18" charset="0"/>
                </a:rPr>
                <a:t>Principal coordinates analysis of fungal ITS  sequences from root (A) and soil (B) samples across different soil ages. Figures present beta diversity of communities based on Bray-Curtis analysis</a:t>
              </a:r>
              <a:r>
                <a:rPr lang="en-US" sz="1200" dirty="0">
                  <a:solidFill>
                    <a:srgbClr val="44546A"/>
                  </a:solidFill>
                  <a:latin typeface="PalatinoLinotype"/>
                </a:rPr>
                <a:t>.</a:t>
              </a:r>
              <a:r>
                <a:rPr lang="en-US" sz="1200" dirty="0">
                  <a:solidFill>
                    <a:srgbClr val="44546A"/>
                  </a:solidFill>
                  <a:latin typeface="Times New Roman" panose="02020603050405020304" pitchFamily="18" charset="0"/>
                </a:rPr>
                <a:t> </a:t>
              </a:r>
              <a:r>
                <a:rPr lang="fr-FR" sz="1200" dirty="0" err="1">
                  <a:solidFill>
                    <a:srgbClr val="44546A"/>
                  </a:solidFill>
                  <a:latin typeface="Times New Roman" panose="02020603050405020304" pitchFamily="18" charset="0"/>
                </a:rPr>
                <a:t>Soil</a:t>
              </a:r>
              <a:r>
                <a:rPr lang="fr-FR" sz="1200" dirty="0">
                  <a:solidFill>
                    <a:srgbClr val="44546A"/>
                  </a:solidFill>
                  <a:latin typeface="Times New Roman" panose="02020603050405020304" pitchFamily="18" charset="0"/>
                </a:rPr>
                <a:t> </a:t>
              </a:r>
              <a:r>
                <a:rPr lang="fr-FR" sz="1200" dirty="0" err="1">
                  <a:solidFill>
                    <a:srgbClr val="44546A"/>
                  </a:solidFill>
                  <a:latin typeface="Times New Roman" panose="02020603050405020304" pitchFamily="18" charset="0"/>
                </a:rPr>
                <a:t>ages</a:t>
              </a:r>
              <a:r>
                <a:rPr lang="fr-FR" sz="1200" dirty="0">
                  <a:solidFill>
                    <a:srgbClr val="44546A"/>
                  </a:solidFill>
                  <a:latin typeface="Times New Roman" panose="02020603050405020304" pitchFamily="18" charset="0"/>
                </a:rPr>
                <a:t> are </a:t>
              </a:r>
              <a:r>
                <a:rPr lang="fr-FR" sz="1200" dirty="0" err="1">
                  <a:solidFill>
                    <a:srgbClr val="44546A"/>
                  </a:solidFill>
                  <a:latin typeface="Times New Roman" panose="02020603050405020304" pitchFamily="18" charset="0"/>
                </a:rPr>
                <a:t>indicated</a:t>
              </a:r>
              <a:r>
                <a:rPr lang="fr-FR" sz="1200" dirty="0">
                  <a:solidFill>
                    <a:srgbClr val="44546A"/>
                  </a:solidFill>
                  <a:latin typeface="Times New Roman" panose="02020603050405020304" pitchFamily="18" charset="0"/>
                </a:rPr>
                <a:t> by </a:t>
              </a:r>
              <a:r>
                <a:rPr lang="fr-FR" sz="1200" dirty="0" err="1">
                  <a:solidFill>
                    <a:srgbClr val="44546A"/>
                  </a:solidFill>
                  <a:latin typeface="Times New Roman" panose="02020603050405020304" pitchFamily="18" charset="0"/>
                </a:rPr>
                <a:t>different</a:t>
              </a:r>
              <a:r>
                <a:rPr lang="fr-FR" sz="1200" dirty="0">
                  <a:solidFill>
                    <a:srgbClr val="44546A"/>
                  </a:solidFill>
                  <a:latin typeface="Times New Roman" panose="02020603050405020304" pitchFamily="18" charset="0"/>
                </a:rPr>
                <a:t> </a:t>
              </a:r>
              <a:r>
                <a:rPr lang="fr-FR" sz="1200" dirty="0" err="1">
                  <a:solidFill>
                    <a:srgbClr val="44546A"/>
                  </a:solidFill>
                  <a:latin typeface="Times New Roman" panose="02020603050405020304" pitchFamily="18" charset="0"/>
                </a:rPr>
                <a:t>colors</a:t>
              </a:r>
              <a:r>
                <a:rPr lang="fr-FR" sz="1200" dirty="0">
                  <a:solidFill>
                    <a:srgbClr val="44546A"/>
                  </a:solidFill>
                  <a:latin typeface="Times New Roman" panose="02020603050405020304" pitchFamily="18" charset="0"/>
                </a:rPr>
                <a:t>.</a:t>
              </a:r>
              <a:endParaRPr lang="fr-FR" sz="1200" dirty="0">
                <a:solidFill>
                  <a:srgbClr val="44546A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  <p:pic>
        <p:nvPicPr>
          <p:cNvPr id="6" name="Picture 5" descr="A graph with many colored dots&#10;&#10;Description automatically generated">
            <a:extLst>
              <a:ext uri="{FF2B5EF4-FFF2-40B4-BE49-F238E27FC236}">
                <a16:creationId xmlns:a16="http://schemas.microsoft.com/office/drawing/2014/main" id="{84BA89C9-1F2A-5D70-4391-4989235B7E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9850" y="1672353"/>
            <a:ext cx="4046400" cy="2811405"/>
          </a:xfrm>
          <a:prstGeom prst="rect">
            <a:avLst/>
          </a:prstGeom>
        </p:spPr>
      </p:pic>
      <p:pic>
        <p:nvPicPr>
          <p:cNvPr id="12" name="Picture 11" descr="A graph with many colored dots&#10;&#10;Description automatically generated">
            <a:extLst>
              <a:ext uri="{FF2B5EF4-FFF2-40B4-BE49-F238E27FC236}">
                <a16:creationId xmlns:a16="http://schemas.microsoft.com/office/drawing/2014/main" id="{301644D0-F087-4A0B-74BA-3B32A01ACA4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75282" y="1672353"/>
            <a:ext cx="4046401" cy="28114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420449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7">
            <a:extLst>
              <a:ext uri="{FF2B5EF4-FFF2-40B4-BE49-F238E27FC236}">
                <a16:creationId xmlns:a16="http://schemas.microsoft.com/office/drawing/2014/main" id="{7D282314-AD4C-20F9-39AD-D1869F81BC5D}"/>
              </a:ext>
            </a:extLst>
          </p:cNvPr>
          <p:cNvSpPr txBox="1">
            <a:spLocks/>
          </p:cNvSpPr>
          <p:nvPr/>
        </p:nvSpPr>
        <p:spPr>
          <a:xfrm>
            <a:off x="2724739" y="5170780"/>
            <a:ext cx="6259241" cy="999304"/>
          </a:xfrm>
          <a:prstGeom prst="rect">
            <a:avLst/>
          </a:prstGeom>
          <a:solidFill>
            <a:prstClr val="white"/>
          </a:solidFill>
          <a:ln>
            <a:noFill/>
          </a:ln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defTabSz="1133856">
              <a:spcAft>
                <a:spcPts val="1240"/>
              </a:spcAft>
            </a:pPr>
            <a:r>
              <a:rPr lang="en-US" sz="1116" b="1" kern="1200" dirty="0">
                <a:solidFill>
                  <a:srgbClr val="FF0000"/>
                </a:solidFill>
                <a:latin typeface="Times New Roman" panose="02020603050405020304" pitchFamily="18" charset="0"/>
                <a:ea typeface="+mn-ea"/>
                <a:cs typeface="+mn-cs"/>
              </a:rPr>
              <a:t>Fig. S4. </a:t>
            </a:r>
            <a:r>
              <a:rPr lang="en-US" sz="1100" dirty="0">
                <a:solidFill>
                  <a:srgbClr val="44546A"/>
                </a:solidFill>
                <a:latin typeface="Times New Roman" panose="02020603050405020304" pitchFamily="18" charset="0"/>
              </a:rPr>
              <a:t>Class-level relative abundance of 20 top fungal</a:t>
            </a:r>
            <a:r>
              <a:rPr lang="he-IL" sz="1100" dirty="0">
                <a:solidFill>
                  <a:srgbClr val="44546A"/>
                </a:solidFill>
                <a:latin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srgbClr val="44546A"/>
                </a:solidFill>
                <a:latin typeface="Times New Roman" panose="02020603050405020304" pitchFamily="18" charset="0"/>
              </a:rPr>
              <a:t>taxa in root and soil. A-H: root and soil samples at different soil ages (A = 0 months, B = 6 months, C = 12 months, D = 18 months, E = 24 months, F = 30 months, G= 36 months, H= 42 months. Colored blocks represent individual classes.</a:t>
            </a:r>
            <a:endParaRPr lang="fr-FR" sz="1100" dirty="0">
              <a:solidFill>
                <a:srgbClr val="44546A"/>
              </a:solidFill>
              <a:latin typeface="Times New Roman" panose="02020603050405020304" pitchFamily="18" charset="0"/>
            </a:endParaRPr>
          </a:p>
          <a:p>
            <a:pPr defTabSz="1133856">
              <a:spcAft>
                <a:spcPts val="1240"/>
              </a:spcAft>
            </a:pPr>
            <a:endParaRPr lang="en-US" sz="1116" i="1" kern="1200" dirty="0">
              <a:solidFill>
                <a:srgbClr val="44546A"/>
              </a:solidFill>
              <a:latin typeface="Times New Roman" panose="02020603050405020304" pitchFamily="18" charset="0"/>
              <a:ea typeface="+mn-ea"/>
              <a:cs typeface="+mn-cs"/>
            </a:endParaRPr>
          </a:p>
        </p:txBody>
      </p:sp>
      <p:pic>
        <p:nvPicPr>
          <p:cNvPr id="7" name="Picture 6" descr="A chart with colorful lines and text">
            <a:extLst>
              <a:ext uri="{FF2B5EF4-FFF2-40B4-BE49-F238E27FC236}">
                <a16:creationId xmlns:a16="http://schemas.microsoft.com/office/drawing/2014/main" id="{99BD86B9-BDD0-AE92-CFA5-0F7B495F33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53529" y="342052"/>
            <a:ext cx="7318292" cy="46837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71295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304</TotalTime>
  <Words>1090</Words>
  <Application>Microsoft Office PowerPoint</Application>
  <PresentationFormat>Widescreen</PresentationFormat>
  <Paragraphs>461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7" baseType="lpstr">
      <vt:lpstr>Aptos</vt:lpstr>
      <vt:lpstr>Aptos Display</vt:lpstr>
      <vt:lpstr>Arial</vt:lpstr>
      <vt:lpstr>Calibri</vt:lpstr>
      <vt:lpstr>David</vt:lpstr>
      <vt:lpstr>PalatinoLinotype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Da Cohen</dc:creator>
  <cp:lastModifiedBy>David Da Cohen</cp:lastModifiedBy>
  <cp:revision>19</cp:revision>
  <dcterms:created xsi:type="dcterms:W3CDTF">2024-11-18T13:16:15Z</dcterms:created>
  <dcterms:modified xsi:type="dcterms:W3CDTF">2025-01-26T09:59:16Z</dcterms:modified>
</cp:coreProperties>
</file>